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9" r:id="rId3"/>
    <p:sldId id="257" r:id="rId4"/>
  </p:sldIdLst>
  <p:sldSz cx="6227763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5D7819B-D6D1-4CF1-8377-6A023AE00D40}" v="39" dt="2024-02-02T10:10:43.23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2386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iden Hendrickx" userId="b3e63f82dea26a3f" providerId="LiveId" clId="{C5D7819B-D6D1-4CF1-8377-6A023AE00D40}"/>
    <pc:docChg chg="undo custSel addSld delSld modSld">
      <pc:chgData name="Aiden Hendrickx" userId="b3e63f82dea26a3f" providerId="LiveId" clId="{C5D7819B-D6D1-4CF1-8377-6A023AE00D40}" dt="2024-02-02T10:11:49.378" v="1223" actId="47"/>
      <pc:docMkLst>
        <pc:docMk/>
      </pc:docMkLst>
      <pc:sldChg chg="addSp delSp modSp mod">
        <pc:chgData name="Aiden Hendrickx" userId="b3e63f82dea26a3f" providerId="LiveId" clId="{C5D7819B-D6D1-4CF1-8377-6A023AE00D40}" dt="2024-02-02T10:05:54.347" v="1059" actId="1035"/>
        <pc:sldMkLst>
          <pc:docMk/>
          <pc:sldMk cId="2456899660" sldId="256"/>
        </pc:sldMkLst>
        <pc:spChg chg="add del mod">
          <ac:chgData name="Aiden Hendrickx" userId="b3e63f82dea26a3f" providerId="LiveId" clId="{C5D7819B-D6D1-4CF1-8377-6A023AE00D40}" dt="2024-02-02T09:43:47.478" v="6" actId="21"/>
          <ac:spMkLst>
            <pc:docMk/>
            <pc:sldMk cId="2456899660" sldId="256"/>
            <ac:spMk id="2" creationId="{5FFCEC1F-25EC-508A-68F7-38E933843F66}"/>
          </ac:spMkLst>
        </pc:spChg>
        <pc:spChg chg="mod">
          <ac:chgData name="Aiden Hendrickx" userId="b3e63f82dea26a3f" providerId="LiveId" clId="{C5D7819B-D6D1-4CF1-8377-6A023AE00D40}" dt="2024-02-02T10:00:05.263" v="470" actId="165"/>
          <ac:spMkLst>
            <pc:docMk/>
            <pc:sldMk cId="2456899660" sldId="256"/>
            <ac:spMk id="3" creationId="{6E1B0303-C9E8-9B6B-493C-61F9C035D847}"/>
          </ac:spMkLst>
        </pc:spChg>
        <pc:spChg chg="mod">
          <ac:chgData name="Aiden Hendrickx" userId="b3e63f82dea26a3f" providerId="LiveId" clId="{C5D7819B-D6D1-4CF1-8377-6A023AE00D40}" dt="2024-02-02T10:02:56.488" v="817" actId="165"/>
          <ac:spMkLst>
            <pc:docMk/>
            <pc:sldMk cId="2456899660" sldId="256"/>
            <ac:spMk id="6" creationId="{17ED35B2-7D1D-AF66-560E-18F4AD15095D}"/>
          </ac:spMkLst>
        </pc:spChg>
        <pc:spChg chg="mod">
          <ac:chgData name="Aiden Hendrickx" userId="b3e63f82dea26a3f" providerId="LiveId" clId="{C5D7819B-D6D1-4CF1-8377-6A023AE00D40}" dt="2024-02-02T09:57:37.457" v="323" actId="165"/>
          <ac:spMkLst>
            <pc:docMk/>
            <pc:sldMk cId="2456899660" sldId="256"/>
            <ac:spMk id="10" creationId="{9E9D8DCC-D327-53A1-7D2E-5C968117600C}"/>
          </ac:spMkLst>
        </pc:spChg>
        <pc:spChg chg="add del mod">
          <ac:chgData name="Aiden Hendrickx" userId="b3e63f82dea26a3f" providerId="LiveId" clId="{C5D7819B-D6D1-4CF1-8377-6A023AE00D40}" dt="2024-02-02T09:43:47.478" v="6" actId="21"/>
          <ac:spMkLst>
            <pc:docMk/>
            <pc:sldMk cId="2456899660" sldId="256"/>
            <ac:spMk id="13" creationId="{705E5F52-BF4C-C293-A585-0B43CA7AFE6A}"/>
          </ac:spMkLst>
        </pc:spChg>
        <pc:spChg chg="add del mod">
          <ac:chgData name="Aiden Hendrickx" userId="b3e63f82dea26a3f" providerId="LiveId" clId="{C5D7819B-D6D1-4CF1-8377-6A023AE00D40}" dt="2024-02-02T09:43:47.478" v="6" actId="21"/>
          <ac:spMkLst>
            <pc:docMk/>
            <pc:sldMk cId="2456899660" sldId="256"/>
            <ac:spMk id="14" creationId="{4ABD0B06-1BEA-34FC-0C28-6EF44D32586E}"/>
          </ac:spMkLst>
        </pc:spChg>
        <pc:spChg chg="add del mod">
          <ac:chgData name="Aiden Hendrickx" userId="b3e63f82dea26a3f" providerId="LiveId" clId="{C5D7819B-D6D1-4CF1-8377-6A023AE00D40}" dt="2024-02-02T09:43:47.478" v="6" actId="21"/>
          <ac:spMkLst>
            <pc:docMk/>
            <pc:sldMk cId="2456899660" sldId="256"/>
            <ac:spMk id="15" creationId="{27E23BDF-E4F2-8BFC-21A3-D07E3F48E163}"/>
          </ac:spMkLst>
        </pc:spChg>
        <pc:spChg chg="add del mod">
          <ac:chgData name="Aiden Hendrickx" userId="b3e63f82dea26a3f" providerId="LiveId" clId="{C5D7819B-D6D1-4CF1-8377-6A023AE00D40}" dt="2024-02-02T09:43:47.478" v="6" actId="21"/>
          <ac:spMkLst>
            <pc:docMk/>
            <pc:sldMk cId="2456899660" sldId="256"/>
            <ac:spMk id="16" creationId="{D43E8269-EA9D-7243-A227-914AED581729}"/>
          </ac:spMkLst>
        </pc:spChg>
        <pc:spChg chg="add del mod">
          <ac:chgData name="Aiden Hendrickx" userId="b3e63f82dea26a3f" providerId="LiveId" clId="{C5D7819B-D6D1-4CF1-8377-6A023AE00D40}" dt="2024-02-02T09:43:47.478" v="6" actId="21"/>
          <ac:spMkLst>
            <pc:docMk/>
            <pc:sldMk cId="2456899660" sldId="256"/>
            <ac:spMk id="17" creationId="{BE1AECCE-E9E8-FD34-B36E-398E046F959B}"/>
          </ac:spMkLst>
        </pc:spChg>
        <pc:spChg chg="add mod">
          <ac:chgData name="Aiden Hendrickx" userId="b3e63f82dea26a3f" providerId="LiveId" clId="{C5D7819B-D6D1-4CF1-8377-6A023AE00D40}" dt="2024-02-02T10:00:05.263" v="470" actId="165"/>
          <ac:spMkLst>
            <pc:docMk/>
            <pc:sldMk cId="2456899660" sldId="256"/>
            <ac:spMk id="21" creationId="{27E23BDF-E4F2-8BFC-21A3-D07E3F48E163}"/>
          </ac:spMkLst>
        </pc:spChg>
        <pc:spChg chg="add mod">
          <ac:chgData name="Aiden Hendrickx" userId="b3e63f82dea26a3f" providerId="LiveId" clId="{C5D7819B-D6D1-4CF1-8377-6A023AE00D40}" dt="2024-02-02T10:00:05.263" v="470" actId="165"/>
          <ac:spMkLst>
            <pc:docMk/>
            <pc:sldMk cId="2456899660" sldId="256"/>
            <ac:spMk id="22" creationId="{638F7C47-494E-2C31-3C18-898A3009FD90}"/>
          </ac:spMkLst>
        </pc:spChg>
        <pc:spChg chg="add mod">
          <ac:chgData name="Aiden Hendrickx" userId="b3e63f82dea26a3f" providerId="LiveId" clId="{C5D7819B-D6D1-4CF1-8377-6A023AE00D40}" dt="2024-02-02T10:00:05.263" v="470" actId="165"/>
          <ac:spMkLst>
            <pc:docMk/>
            <pc:sldMk cId="2456899660" sldId="256"/>
            <ac:spMk id="27" creationId="{228D41F5-7827-E5DC-734D-09DD244BA124}"/>
          </ac:spMkLst>
        </pc:spChg>
        <pc:spChg chg="add mod">
          <ac:chgData name="Aiden Hendrickx" userId="b3e63f82dea26a3f" providerId="LiveId" clId="{C5D7819B-D6D1-4CF1-8377-6A023AE00D40}" dt="2024-02-02T10:00:05.263" v="470" actId="165"/>
          <ac:spMkLst>
            <pc:docMk/>
            <pc:sldMk cId="2456899660" sldId="256"/>
            <ac:spMk id="28" creationId="{AEA7A2F6-DA6C-BD6D-A20D-4ACCAF056EC5}"/>
          </ac:spMkLst>
        </pc:spChg>
        <pc:spChg chg="add mod">
          <ac:chgData name="Aiden Hendrickx" userId="b3e63f82dea26a3f" providerId="LiveId" clId="{C5D7819B-D6D1-4CF1-8377-6A023AE00D40}" dt="2024-02-02T10:00:05.263" v="470" actId="165"/>
          <ac:spMkLst>
            <pc:docMk/>
            <pc:sldMk cId="2456899660" sldId="256"/>
            <ac:spMk id="31" creationId="{73735F3E-CBE1-47A9-ED31-728AD82DDA97}"/>
          </ac:spMkLst>
        </pc:spChg>
        <pc:spChg chg="add mod">
          <ac:chgData name="Aiden Hendrickx" userId="b3e63f82dea26a3f" providerId="LiveId" clId="{C5D7819B-D6D1-4CF1-8377-6A023AE00D40}" dt="2024-02-02T10:00:05.263" v="470" actId="165"/>
          <ac:spMkLst>
            <pc:docMk/>
            <pc:sldMk cId="2456899660" sldId="256"/>
            <ac:spMk id="32" creationId="{04FFFDD8-911A-DFF1-23FA-7030C31C0EA0}"/>
          </ac:spMkLst>
        </pc:spChg>
        <pc:spChg chg="add mod">
          <ac:chgData name="Aiden Hendrickx" userId="b3e63f82dea26a3f" providerId="LiveId" clId="{C5D7819B-D6D1-4CF1-8377-6A023AE00D40}" dt="2024-02-02T10:00:05.263" v="470" actId="165"/>
          <ac:spMkLst>
            <pc:docMk/>
            <pc:sldMk cId="2456899660" sldId="256"/>
            <ac:spMk id="33" creationId="{C7F0AEAD-961C-E548-0EA2-15578BF3A30E}"/>
          </ac:spMkLst>
        </pc:spChg>
        <pc:spChg chg="add mod">
          <ac:chgData name="Aiden Hendrickx" userId="b3e63f82dea26a3f" providerId="LiveId" clId="{C5D7819B-D6D1-4CF1-8377-6A023AE00D40}" dt="2024-02-02T10:00:05.263" v="470" actId="165"/>
          <ac:spMkLst>
            <pc:docMk/>
            <pc:sldMk cId="2456899660" sldId="256"/>
            <ac:spMk id="34" creationId="{18B7A273-07BA-C243-4BD2-DA6BD6B05473}"/>
          </ac:spMkLst>
        </pc:spChg>
        <pc:spChg chg="mod">
          <ac:chgData name="Aiden Hendrickx" userId="b3e63f82dea26a3f" providerId="LiveId" clId="{C5D7819B-D6D1-4CF1-8377-6A023AE00D40}" dt="2024-02-02T09:57:47.316" v="324"/>
          <ac:spMkLst>
            <pc:docMk/>
            <pc:sldMk cId="2456899660" sldId="256"/>
            <ac:spMk id="38" creationId="{F70EC0B0-DB7E-AAC6-FAC6-CBF2EFFCDE41}"/>
          </ac:spMkLst>
        </pc:spChg>
        <pc:spChg chg="mod">
          <ac:chgData name="Aiden Hendrickx" userId="b3e63f82dea26a3f" providerId="LiveId" clId="{C5D7819B-D6D1-4CF1-8377-6A023AE00D40}" dt="2024-02-02T09:57:47.316" v="324"/>
          <ac:spMkLst>
            <pc:docMk/>
            <pc:sldMk cId="2456899660" sldId="256"/>
            <ac:spMk id="39" creationId="{27C923AD-FCD3-6B02-A702-FDF45A8BFEAE}"/>
          </ac:spMkLst>
        </pc:spChg>
        <pc:spChg chg="mod">
          <ac:chgData name="Aiden Hendrickx" userId="b3e63f82dea26a3f" providerId="LiveId" clId="{C5D7819B-D6D1-4CF1-8377-6A023AE00D40}" dt="2024-02-02T09:57:47.316" v="324"/>
          <ac:spMkLst>
            <pc:docMk/>
            <pc:sldMk cId="2456899660" sldId="256"/>
            <ac:spMk id="40" creationId="{279363B0-436C-9467-9E8A-F7F4E534D206}"/>
          </ac:spMkLst>
        </pc:spChg>
        <pc:spChg chg="mod">
          <ac:chgData name="Aiden Hendrickx" userId="b3e63f82dea26a3f" providerId="LiveId" clId="{C5D7819B-D6D1-4CF1-8377-6A023AE00D40}" dt="2024-02-02T09:57:47.316" v="324"/>
          <ac:spMkLst>
            <pc:docMk/>
            <pc:sldMk cId="2456899660" sldId="256"/>
            <ac:spMk id="41" creationId="{9DB39D1F-EF52-8CC5-C6CA-5BC2AB058239}"/>
          </ac:spMkLst>
        </pc:spChg>
        <pc:spChg chg="mod">
          <ac:chgData name="Aiden Hendrickx" userId="b3e63f82dea26a3f" providerId="LiveId" clId="{C5D7819B-D6D1-4CF1-8377-6A023AE00D40}" dt="2024-02-02T09:57:47.316" v="324"/>
          <ac:spMkLst>
            <pc:docMk/>
            <pc:sldMk cId="2456899660" sldId="256"/>
            <ac:spMk id="42" creationId="{BB8B7A7B-0FEC-BD2D-7F67-0307DEB438BC}"/>
          </ac:spMkLst>
        </pc:spChg>
        <pc:spChg chg="mod">
          <ac:chgData name="Aiden Hendrickx" userId="b3e63f82dea26a3f" providerId="LiveId" clId="{C5D7819B-D6D1-4CF1-8377-6A023AE00D40}" dt="2024-02-02T09:57:47.316" v="324"/>
          <ac:spMkLst>
            <pc:docMk/>
            <pc:sldMk cId="2456899660" sldId="256"/>
            <ac:spMk id="43" creationId="{89F5F6DE-CA40-4EEC-3949-3FA33AC72790}"/>
          </ac:spMkLst>
        </pc:spChg>
        <pc:spChg chg="mod">
          <ac:chgData name="Aiden Hendrickx" userId="b3e63f82dea26a3f" providerId="LiveId" clId="{C5D7819B-D6D1-4CF1-8377-6A023AE00D40}" dt="2024-02-02T09:57:47.316" v="324"/>
          <ac:spMkLst>
            <pc:docMk/>
            <pc:sldMk cId="2456899660" sldId="256"/>
            <ac:spMk id="45" creationId="{C4B1C91C-0FA0-FAD3-AC54-C681E1B6880C}"/>
          </ac:spMkLst>
        </pc:spChg>
        <pc:spChg chg="mod">
          <ac:chgData name="Aiden Hendrickx" userId="b3e63f82dea26a3f" providerId="LiveId" clId="{C5D7819B-D6D1-4CF1-8377-6A023AE00D40}" dt="2024-02-02T09:57:47.316" v="324"/>
          <ac:spMkLst>
            <pc:docMk/>
            <pc:sldMk cId="2456899660" sldId="256"/>
            <ac:spMk id="46" creationId="{27A77D0D-A73A-0420-E816-0E44D41AE189}"/>
          </ac:spMkLst>
        </pc:spChg>
        <pc:spChg chg="mod">
          <ac:chgData name="Aiden Hendrickx" userId="b3e63f82dea26a3f" providerId="LiveId" clId="{C5D7819B-D6D1-4CF1-8377-6A023AE00D40}" dt="2024-02-02T09:57:47.938" v="325"/>
          <ac:spMkLst>
            <pc:docMk/>
            <pc:sldMk cId="2456899660" sldId="256"/>
            <ac:spMk id="49" creationId="{50DC9EE8-B638-3E7E-8BF6-450FCA833232}"/>
          </ac:spMkLst>
        </pc:spChg>
        <pc:spChg chg="mod">
          <ac:chgData name="Aiden Hendrickx" userId="b3e63f82dea26a3f" providerId="LiveId" clId="{C5D7819B-D6D1-4CF1-8377-6A023AE00D40}" dt="2024-02-02T09:57:47.938" v="325"/>
          <ac:spMkLst>
            <pc:docMk/>
            <pc:sldMk cId="2456899660" sldId="256"/>
            <ac:spMk id="50" creationId="{CF1D43A3-3B0E-9146-FBA0-411592232F4D}"/>
          </ac:spMkLst>
        </pc:spChg>
        <pc:spChg chg="mod">
          <ac:chgData name="Aiden Hendrickx" userId="b3e63f82dea26a3f" providerId="LiveId" clId="{C5D7819B-D6D1-4CF1-8377-6A023AE00D40}" dt="2024-02-02T09:57:47.938" v="325"/>
          <ac:spMkLst>
            <pc:docMk/>
            <pc:sldMk cId="2456899660" sldId="256"/>
            <ac:spMk id="51" creationId="{CA42F84B-3BCE-AC58-9BB0-84E6D019B7B1}"/>
          </ac:spMkLst>
        </pc:spChg>
        <pc:spChg chg="mod">
          <ac:chgData name="Aiden Hendrickx" userId="b3e63f82dea26a3f" providerId="LiveId" clId="{C5D7819B-D6D1-4CF1-8377-6A023AE00D40}" dt="2024-02-02T09:57:47.938" v="325"/>
          <ac:spMkLst>
            <pc:docMk/>
            <pc:sldMk cId="2456899660" sldId="256"/>
            <ac:spMk id="52" creationId="{0E1B7F3B-B66F-5ABE-0B4A-4F63170066C4}"/>
          </ac:spMkLst>
        </pc:spChg>
        <pc:spChg chg="mod">
          <ac:chgData name="Aiden Hendrickx" userId="b3e63f82dea26a3f" providerId="LiveId" clId="{C5D7819B-D6D1-4CF1-8377-6A023AE00D40}" dt="2024-02-02T09:57:47.938" v="325"/>
          <ac:spMkLst>
            <pc:docMk/>
            <pc:sldMk cId="2456899660" sldId="256"/>
            <ac:spMk id="53" creationId="{FEC57E25-ED4F-BA7E-84AC-83C777FB12FA}"/>
          </ac:spMkLst>
        </pc:spChg>
        <pc:spChg chg="mod">
          <ac:chgData name="Aiden Hendrickx" userId="b3e63f82dea26a3f" providerId="LiveId" clId="{C5D7819B-D6D1-4CF1-8377-6A023AE00D40}" dt="2024-02-02T09:57:47.938" v="325"/>
          <ac:spMkLst>
            <pc:docMk/>
            <pc:sldMk cId="2456899660" sldId="256"/>
            <ac:spMk id="54" creationId="{5AE33F5D-5FA0-475D-7915-5E8612798D1E}"/>
          </ac:spMkLst>
        </pc:spChg>
        <pc:spChg chg="mod">
          <ac:chgData name="Aiden Hendrickx" userId="b3e63f82dea26a3f" providerId="LiveId" clId="{C5D7819B-D6D1-4CF1-8377-6A023AE00D40}" dt="2024-02-02T09:57:47.938" v="325"/>
          <ac:spMkLst>
            <pc:docMk/>
            <pc:sldMk cId="2456899660" sldId="256"/>
            <ac:spMk id="56" creationId="{DDFD997F-18AF-EE65-8ADD-E0104E2E1CB2}"/>
          </ac:spMkLst>
        </pc:spChg>
        <pc:spChg chg="mod">
          <ac:chgData name="Aiden Hendrickx" userId="b3e63f82dea26a3f" providerId="LiveId" clId="{C5D7819B-D6D1-4CF1-8377-6A023AE00D40}" dt="2024-02-02T09:57:47.938" v="325"/>
          <ac:spMkLst>
            <pc:docMk/>
            <pc:sldMk cId="2456899660" sldId="256"/>
            <ac:spMk id="57" creationId="{BB149FDF-DAFE-A31C-9947-403155A42261}"/>
          </ac:spMkLst>
        </pc:spChg>
        <pc:spChg chg="mod">
          <ac:chgData name="Aiden Hendrickx" userId="b3e63f82dea26a3f" providerId="LiveId" clId="{C5D7819B-D6D1-4CF1-8377-6A023AE00D40}" dt="2024-02-02T10:02:12.752" v="808" actId="164"/>
          <ac:spMkLst>
            <pc:docMk/>
            <pc:sldMk cId="2456899660" sldId="256"/>
            <ac:spMk id="61" creationId="{C88FBC59-1C58-6D0F-A0EE-7EC87B68A0DD}"/>
          </ac:spMkLst>
        </pc:spChg>
        <pc:spChg chg="mod">
          <ac:chgData name="Aiden Hendrickx" userId="b3e63f82dea26a3f" providerId="LiveId" clId="{C5D7819B-D6D1-4CF1-8377-6A023AE00D40}" dt="2024-02-02T10:02:12.752" v="808" actId="164"/>
          <ac:spMkLst>
            <pc:docMk/>
            <pc:sldMk cId="2456899660" sldId="256"/>
            <ac:spMk id="62" creationId="{93A44C95-4E7D-460B-1C46-9C44D8C91C1C}"/>
          </ac:spMkLst>
        </pc:spChg>
        <pc:spChg chg="mod">
          <ac:chgData name="Aiden Hendrickx" userId="b3e63f82dea26a3f" providerId="LiveId" clId="{C5D7819B-D6D1-4CF1-8377-6A023AE00D40}" dt="2024-02-02T10:02:12.752" v="808" actId="164"/>
          <ac:spMkLst>
            <pc:docMk/>
            <pc:sldMk cId="2456899660" sldId="256"/>
            <ac:spMk id="63" creationId="{5BF17295-3440-C6F5-89D0-89BA22466F0E}"/>
          </ac:spMkLst>
        </pc:spChg>
        <pc:spChg chg="mod">
          <ac:chgData name="Aiden Hendrickx" userId="b3e63f82dea26a3f" providerId="LiveId" clId="{C5D7819B-D6D1-4CF1-8377-6A023AE00D40}" dt="2024-02-02T10:02:12.752" v="808" actId="164"/>
          <ac:spMkLst>
            <pc:docMk/>
            <pc:sldMk cId="2456899660" sldId="256"/>
            <ac:spMk id="64" creationId="{B9928814-C07F-1FED-EAA0-E249F254BAEC}"/>
          </ac:spMkLst>
        </pc:spChg>
        <pc:spChg chg="mod">
          <ac:chgData name="Aiden Hendrickx" userId="b3e63f82dea26a3f" providerId="LiveId" clId="{C5D7819B-D6D1-4CF1-8377-6A023AE00D40}" dt="2024-02-02T10:02:12.752" v="808" actId="164"/>
          <ac:spMkLst>
            <pc:docMk/>
            <pc:sldMk cId="2456899660" sldId="256"/>
            <ac:spMk id="65" creationId="{4693A916-C85F-3D34-00CB-5DF4258BB5DB}"/>
          </ac:spMkLst>
        </pc:spChg>
        <pc:spChg chg="mod">
          <ac:chgData name="Aiden Hendrickx" userId="b3e63f82dea26a3f" providerId="LiveId" clId="{C5D7819B-D6D1-4CF1-8377-6A023AE00D40}" dt="2024-02-02T10:02:12.752" v="808" actId="164"/>
          <ac:spMkLst>
            <pc:docMk/>
            <pc:sldMk cId="2456899660" sldId="256"/>
            <ac:spMk id="66" creationId="{986B22C1-693D-A24A-000E-61F26848896A}"/>
          </ac:spMkLst>
        </pc:spChg>
        <pc:spChg chg="mod">
          <ac:chgData name="Aiden Hendrickx" userId="b3e63f82dea26a3f" providerId="LiveId" clId="{C5D7819B-D6D1-4CF1-8377-6A023AE00D40}" dt="2024-02-02T10:02:12.752" v="808" actId="164"/>
          <ac:spMkLst>
            <pc:docMk/>
            <pc:sldMk cId="2456899660" sldId="256"/>
            <ac:spMk id="68" creationId="{403A6A37-7FC4-8E11-0D5C-4CB31C57D219}"/>
          </ac:spMkLst>
        </pc:spChg>
        <pc:spChg chg="mod">
          <ac:chgData name="Aiden Hendrickx" userId="b3e63f82dea26a3f" providerId="LiveId" clId="{C5D7819B-D6D1-4CF1-8377-6A023AE00D40}" dt="2024-02-02T10:02:12.752" v="808" actId="164"/>
          <ac:spMkLst>
            <pc:docMk/>
            <pc:sldMk cId="2456899660" sldId="256"/>
            <ac:spMk id="69" creationId="{EA1FF848-538E-8D27-87EE-C72B8BBEF2AF}"/>
          </ac:spMkLst>
        </pc:spChg>
        <pc:spChg chg="mod">
          <ac:chgData name="Aiden Hendrickx" userId="b3e63f82dea26a3f" providerId="LiveId" clId="{C5D7819B-D6D1-4CF1-8377-6A023AE00D40}" dt="2024-02-02T10:02:56.488" v="817" actId="165"/>
          <ac:spMkLst>
            <pc:docMk/>
            <pc:sldMk cId="2456899660" sldId="256"/>
            <ac:spMk id="73" creationId="{D80F2C57-DF15-5847-D196-D1ECBD636ABA}"/>
          </ac:spMkLst>
        </pc:spChg>
        <pc:spChg chg="mod">
          <ac:chgData name="Aiden Hendrickx" userId="b3e63f82dea26a3f" providerId="LiveId" clId="{C5D7819B-D6D1-4CF1-8377-6A023AE00D40}" dt="2024-02-02T10:02:56.488" v="817" actId="165"/>
          <ac:spMkLst>
            <pc:docMk/>
            <pc:sldMk cId="2456899660" sldId="256"/>
            <ac:spMk id="74" creationId="{306A9467-A07D-2F72-EE1A-3864E08B9EC2}"/>
          </ac:spMkLst>
        </pc:spChg>
        <pc:spChg chg="mod">
          <ac:chgData name="Aiden Hendrickx" userId="b3e63f82dea26a3f" providerId="LiveId" clId="{C5D7819B-D6D1-4CF1-8377-6A023AE00D40}" dt="2024-02-02T10:02:56.488" v="817" actId="165"/>
          <ac:spMkLst>
            <pc:docMk/>
            <pc:sldMk cId="2456899660" sldId="256"/>
            <ac:spMk id="75" creationId="{E128A322-AAA0-5689-E81C-2CC76AE24D62}"/>
          </ac:spMkLst>
        </pc:spChg>
        <pc:spChg chg="mod">
          <ac:chgData name="Aiden Hendrickx" userId="b3e63f82dea26a3f" providerId="LiveId" clId="{C5D7819B-D6D1-4CF1-8377-6A023AE00D40}" dt="2024-02-02T10:02:56.488" v="817" actId="165"/>
          <ac:spMkLst>
            <pc:docMk/>
            <pc:sldMk cId="2456899660" sldId="256"/>
            <ac:spMk id="76" creationId="{677D5FBD-2C49-8E35-C20B-318C2A349D57}"/>
          </ac:spMkLst>
        </pc:spChg>
        <pc:spChg chg="mod">
          <ac:chgData name="Aiden Hendrickx" userId="b3e63f82dea26a3f" providerId="LiveId" clId="{C5D7819B-D6D1-4CF1-8377-6A023AE00D40}" dt="2024-02-02T10:02:56.488" v="817" actId="165"/>
          <ac:spMkLst>
            <pc:docMk/>
            <pc:sldMk cId="2456899660" sldId="256"/>
            <ac:spMk id="77" creationId="{164486BF-5CB2-6AC8-EC10-F4EBCE27AEE8}"/>
          </ac:spMkLst>
        </pc:spChg>
        <pc:spChg chg="mod">
          <ac:chgData name="Aiden Hendrickx" userId="b3e63f82dea26a3f" providerId="LiveId" clId="{C5D7819B-D6D1-4CF1-8377-6A023AE00D40}" dt="2024-02-02T10:02:56.488" v="817" actId="165"/>
          <ac:spMkLst>
            <pc:docMk/>
            <pc:sldMk cId="2456899660" sldId="256"/>
            <ac:spMk id="78" creationId="{6EC952FE-4313-A142-A6C4-50557A7CDA7A}"/>
          </ac:spMkLst>
        </pc:spChg>
        <pc:spChg chg="mod">
          <ac:chgData name="Aiden Hendrickx" userId="b3e63f82dea26a3f" providerId="LiveId" clId="{C5D7819B-D6D1-4CF1-8377-6A023AE00D40}" dt="2024-02-02T10:02:56.488" v="817" actId="165"/>
          <ac:spMkLst>
            <pc:docMk/>
            <pc:sldMk cId="2456899660" sldId="256"/>
            <ac:spMk id="80" creationId="{1D58DD07-A7E1-0E99-912C-F0D7F1AC5E78}"/>
          </ac:spMkLst>
        </pc:spChg>
        <pc:spChg chg="mod">
          <ac:chgData name="Aiden Hendrickx" userId="b3e63f82dea26a3f" providerId="LiveId" clId="{C5D7819B-D6D1-4CF1-8377-6A023AE00D40}" dt="2024-02-02T10:02:56.488" v="817" actId="165"/>
          <ac:spMkLst>
            <pc:docMk/>
            <pc:sldMk cId="2456899660" sldId="256"/>
            <ac:spMk id="81" creationId="{D7D8A11F-6181-D32D-4186-4E91AD26A3E4}"/>
          </ac:spMkLst>
        </pc:spChg>
        <pc:spChg chg="mod">
          <ac:chgData name="Aiden Hendrickx" userId="b3e63f82dea26a3f" providerId="LiveId" clId="{C5D7819B-D6D1-4CF1-8377-6A023AE00D40}" dt="2024-02-02T10:03:01.599" v="818"/>
          <ac:spMkLst>
            <pc:docMk/>
            <pc:sldMk cId="2456899660" sldId="256"/>
            <ac:spMk id="85" creationId="{FF443B57-25A1-697B-6BB2-F23F8138750D}"/>
          </ac:spMkLst>
        </pc:spChg>
        <pc:spChg chg="mod">
          <ac:chgData name="Aiden Hendrickx" userId="b3e63f82dea26a3f" providerId="LiveId" clId="{C5D7819B-D6D1-4CF1-8377-6A023AE00D40}" dt="2024-02-02T10:03:01.599" v="818"/>
          <ac:spMkLst>
            <pc:docMk/>
            <pc:sldMk cId="2456899660" sldId="256"/>
            <ac:spMk id="86" creationId="{DFAA076A-BB7B-48D5-0B36-1D3BD0447685}"/>
          </ac:spMkLst>
        </pc:spChg>
        <pc:spChg chg="mod">
          <ac:chgData name="Aiden Hendrickx" userId="b3e63f82dea26a3f" providerId="LiveId" clId="{C5D7819B-D6D1-4CF1-8377-6A023AE00D40}" dt="2024-02-02T10:03:01.599" v="818"/>
          <ac:spMkLst>
            <pc:docMk/>
            <pc:sldMk cId="2456899660" sldId="256"/>
            <ac:spMk id="87" creationId="{7FCC0843-332C-AB1A-B395-F14D113FC6A5}"/>
          </ac:spMkLst>
        </pc:spChg>
        <pc:spChg chg="mod">
          <ac:chgData name="Aiden Hendrickx" userId="b3e63f82dea26a3f" providerId="LiveId" clId="{C5D7819B-D6D1-4CF1-8377-6A023AE00D40}" dt="2024-02-02T10:03:01.599" v="818"/>
          <ac:spMkLst>
            <pc:docMk/>
            <pc:sldMk cId="2456899660" sldId="256"/>
            <ac:spMk id="88" creationId="{DD5B8B27-C1D1-35B2-C913-8D7BA8BFFE40}"/>
          </ac:spMkLst>
        </pc:spChg>
        <pc:spChg chg="mod">
          <ac:chgData name="Aiden Hendrickx" userId="b3e63f82dea26a3f" providerId="LiveId" clId="{C5D7819B-D6D1-4CF1-8377-6A023AE00D40}" dt="2024-02-02T10:03:01.599" v="818"/>
          <ac:spMkLst>
            <pc:docMk/>
            <pc:sldMk cId="2456899660" sldId="256"/>
            <ac:spMk id="89" creationId="{3DB4AB7F-77D7-FE71-8B8F-956E704F9879}"/>
          </ac:spMkLst>
        </pc:spChg>
        <pc:spChg chg="mod">
          <ac:chgData name="Aiden Hendrickx" userId="b3e63f82dea26a3f" providerId="LiveId" clId="{C5D7819B-D6D1-4CF1-8377-6A023AE00D40}" dt="2024-02-02T10:03:01.599" v="818"/>
          <ac:spMkLst>
            <pc:docMk/>
            <pc:sldMk cId="2456899660" sldId="256"/>
            <ac:spMk id="90" creationId="{60085EC9-9392-5685-5826-4523AF60B863}"/>
          </ac:spMkLst>
        </pc:spChg>
        <pc:spChg chg="mod">
          <ac:chgData name="Aiden Hendrickx" userId="b3e63f82dea26a3f" providerId="LiveId" clId="{C5D7819B-D6D1-4CF1-8377-6A023AE00D40}" dt="2024-02-02T10:03:01.599" v="818"/>
          <ac:spMkLst>
            <pc:docMk/>
            <pc:sldMk cId="2456899660" sldId="256"/>
            <ac:spMk id="92" creationId="{72314F64-95C8-2F4F-E272-E5D58937AA4B}"/>
          </ac:spMkLst>
        </pc:spChg>
        <pc:spChg chg="mod">
          <ac:chgData name="Aiden Hendrickx" userId="b3e63f82dea26a3f" providerId="LiveId" clId="{C5D7819B-D6D1-4CF1-8377-6A023AE00D40}" dt="2024-02-02T10:03:01.599" v="818"/>
          <ac:spMkLst>
            <pc:docMk/>
            <pc:sldMk cId="2456899660" sldId="256"/>
            <ac:spMk id="93" creationId="{855A8B40-4110-1115-A079-5FC3113248BA}"/>
          </ac:spMkLst>
        </pc:spChg>
        <pc:grpChg chg="mod topLvl">
          <ac:chgData name="Aiden Hendrickx" userId="b3e63f82dea26a3f" providerId="LiveId" clId="{C5D7819B-D6D1-4CF1-8377-6A023AE00D40}" dt="2024-02-02T10:05:38.049" v="1026" actId="164"/>
          <ac:grpSpMkLst>
            <pc:docMk/>
            <pc:sldMk cId="2456899660" sldId="256"/>
            <ac:grpSpMk id="4" creationId="{A6ADA81D-D6D4-E69D-B97D-67922FFCF3ED}"/>
          </ac:grpSpMkLst>
        </pc:grpChg>
        <pc:grpChg chg="mod topLvl">
          <ac:chgData name="Aiden Hendrickx" userId="b3e63f82dea26a3f" providerId="LiveId" clId="{C5D7819B-D6D1-4CF1-8377-6A023AE00D40}" dt="2024-02-02T10:03:19.493" v="893" actId="164"/>
          <ac:grpSpMkLst>
            <pc:docMk/>
            <pc:sldMk cId="2456899660" sldId="256"/>
            <ac:grpSpMk id="8" creationId="{3522054F-2434-B5CE-0CF2-571BE0C3B313}"/>
          </ac:grpSpMkLst>
        </pc:grpChg>
        <pc:grpChg chg="mod topLvl">
          <ac:chgData name="Aiden Hendrickx" userId="b3e63f82dea26a3f" providerId="LiveId" clId="{C5D7819B-D6D1-4CF1-8377-6A023AE00D40}" dt="2024-02-02T10:04:42.359" v="967" actId="164"/>
          <ac:grpSpMkLst>
            <pc:docMk/>
            <pc:sldMk cId="2456899660" sldId="256"/>
            <ac:grpSpMk id="11" creationId="{E42A8C24-A947-9EE5-9494-DF6EE7356EB0}"/>
          </ac:grpSpMkLst>
        </pc:grpChg>
        <pc:grpChg chg="del">
          <ac:chgData name="Aiden Hendrickx" userId="b3e63f82dea26a3f" providerId="LiveId" clId="{C5D7819B-D6D1-4CF1-8377-6A023AE00D40}" dt="2024-02-02T09:57:37.457" v="323" actId="165"/>
          <ac:grpSpMkLst>
            <pc:docMk/>
            <pc:sldMk cId="2456899660" sldId="256"/>
            <ac:grpSpMk id="12" creationId="{89201DDA-1E98-4096-0DFC-B936909E3DDE}"/>
          </ac:grpSpMkLst>
        </pc:grpChg>
        <pc:grpChg chg="add mod">
          <ac:chgData name="Aiden Hendrickx" userId="b3e63f82dea26a3f" providerId="LiveId" clId="{C5D7819B-D6D1-4CF1-8377-6A023AE00D40}" dt="2024-02-02T10:00:05.263" v="470" actId="165"/>
          <ac:grpSpMkLst>
            <pc:docMk/>
            <pc:sldMk cId="2456899660" sldId="256"/>
            <ac:grpSpMk id="29" creationId="{88A25EEE-C67B-6F10-CF95-DB102FC409E7}"/>
          </ac:grpSpMkLst>
        </pc:grpChg>
        <pc:grpChg chg="add mod topLvl">
          <ac:chgData name="Aiden Hendrickx" userId="b3e63f82dea26a3f" providerId="LiveId" clId="{C5D7819B-D6D1-4CF1-8377-6A023AE00D40}" dt="2024-02-02T10:05:38.049" v="1026" actId="164"/>
          <ac:grpSpMkLst>
            <pc:docMk/>
            <pc:sldMk cId="2456899660" sldId="256"/>
            <ac:grpSpMk id="35" creationId="{CFAB2576-79F2-AB07-337D-DD80BB039997}"/>
          </ac:grpSpMkLst>
        </pc:grpChg>
        <pc:grpChg chg="add del mod">
          <ac:chgData name="Aiden Hendrickx" userId="b3e63f82dea26a3f" providerId="LiveId" clId="{C5D7819B-D6D1-4CF1-8377-6A023AE00D40}" dt="2024-02-02T10:01:06.363" v="665" actId="478"/>
          <ac:grpSpMkLst>
            <pc:docMk/>
            <pc:sldMk cId="2456899660" sldId="256"/>
            <ac:grpSpMk id="36" creationId="{BCDAEF69-8300-903D-6BB2-AD8841B8FDD8}"/>
          </ac:grpSpMkLst>
        </pc:grpChg>
        <pc:grpChg chg="mod">
          <ac:chgData name="Aiden Hendrickx" userId="b3e63f82dea26a3f" providerId="LiveId" clId="{C5D7819B-D6D1-4CF1-8377-6A023AE00D40}" dt="2024-02-02T09:57:47.316" v="324"/>
          <ac:grpSpMkLst>
            <pc:docMk/>
            <pc:sldMk cId="2456899660" sldId="256"/>
            <ac:grpSpMk id="37" creationId="{1C181F65-5011-3B87-1B49-CC05D14FF859}"/>
          </ac:grpSpMkLst>
        </pc:grpChg>
        <pc:grpChg chg="add del mod">
          <ac:chgData name="Aiden Hendrickx" userId="b3e63f82dea26a3f" providerId="LiveId" clId="{C5D7819B-D6D1-4CF1-8377-6A023AE00D40}" dt="2024-02-02T09:59:56.380" v="469" actId="478"/>
          <ac:grpSpMkLst>
            <pc:docMk/>
            <pc:sldMk cId="2456899660" sldId="256"/>
            <ac:grpSpMk id="47" creationId="{68A7910D-8E0F-5712-4549-5E48B8C5A600}"/>
          </ac:grpSpMkLst>
        </pc:grpChg>
        <pc:grpChg chg="mod">
          <ac:chgData name="Aiden Hendrickx" userId="b3e63f82dea26a3f" providerId="LiveId" clId="{C5D7819B-D6D1-4CF1-8377-6A023AE00D40}" dt="2024-02-02T09:57:47.938" v="325"/>
          <ac:grpSpMkLst>
            <pc:docMk/>
            <pc:sldMk cId="2456899660" sldId="256"/>
            <ac:grpSpMk id="48" creationId="{4B07A24B-CFF3-8F92-3B4B-D08A4ADB88D6}"/>
          </ac:grpSpMkLst>
        </pc:grpChg>
        <pc:grpChg chg="add del mod">
          <ac:chgData name="Aiden Hendrickx" userId="b3e63f82dea26a3f" providerId="LiveId" clId="{C5D7819B-D6D1-4CF1-8377-6A023AE00D40}" dt="2024-02-02T10:00:05.263" v="470" actId="165"/>
          <ac:grpSpMkLst>
            <pc:docMk/>
            <pc:sldMk cId="2456899660" sldId="256"/>
            <ac:grpSpMk id="58" creationId="{1C167EC5-9535-E367-36D6-9BC632D1B563}"/>
          </ac:grpSpMkLst>
        </pc:grpChg>
        <pc:grpChg chg="add del mod">
          <ac:chgData name="Aiden Hendrickx" userId="b3e63f82dea26a3f" providerId="LiveId" clId="{C5D7819B-D6D1-4CF1-8377-6A023AE00D40}" dt="2024-02-02T10:02:31.419" v="812" actId="478"/>
          <ac:grpSpMkLst>
            <pc:docMk/>
            <pc:sldMk cId="2456899660" sldId="256"/>
            <ac:grpSpMk id="59" creationId="{545731B0-BEB9-D676-ED87-726228BB7402}"/>
          </ac:grpSpMkLst>
        </pc:grpChg>
        <pc:grpChg chg="mod">
          <ac:chgData name="Aiden Hendrickx" userId="b3e63f82dea26a3f" providerId="LiveId" clId="{C5D7819B-D6D1-4CF1-8377-6A023AE00D40}" dt="2024-02-02T10:02:12.752" v="808" actId="164"/>
          <ac:grpSpMkLst>
            <pc:docMk/>
            <pc:sldMk cId="2456899660" sldId="256"/>
            <ac:grpSpMk id="60" creationId="{6996B7B0-3EDB-E4D4-577D-0F68BA33DEDD}"/>
          </ac:grpSpMkLst>
        </pc:grpChg>
        <pc:grpChg chg="add mod">
          <ac:chgData name="Aiden Hendrickx" userId="b3e63f82dea26a3f" providerId="LiveId" clId="{C5D7819B-D6D1-4CF1-8377-6A023AE00D40}" dt="2024-02-02T10:02:12.752" v="808" actId="164"/>
          <ac:grpSpMkLst>
            <pc:docMk/>
            <pc:sldMk cId="2456899660" sldId="256"/>
            <ac:grpSpMk id="70" creationId="{31053266-D6F1-79E2-98F4-CDBEC257EA61}"/>
          </ac:grpSpMkLst>
        </pc:grpChg>
        <pc:grpChg chg="add mod topLvl">
          <ac:chgData name="Aiden Hendrickx" userId="b3e63f82dea26a3f" providerId="LiveId" clId="{C5D7819B-D6D1-4CF1-8377-6A023AE00D40}" dt="2024-02-02T10:03:19.493" v="893" actId="164"/>
          <ac:grpSpMkLst>
            <pc:docMk/>
            <pc:sldMk cId="2456899660" sldId="256"/>
            <ac:grpSpMk id="71" creationId="{99A2B627-7853-8909-647C-54DBA6DFD7E5}"/>
          </ac:grpSpMkLst>
        </pc:grpChg>
        <pc:grpChg chg="mod">
          <ac:chgData name="Aiden Hendrickx" userId="b3e63f82dea26a3f" providerId="LiveId" clId="{C5D7819B-D6D1-4CF1-8377-6A023AE00D40}" dt="2024-02-02T10:02:56.488" v="817" actId="165"/>
          <ac:grpSpMkLst>
            <pc:docMk/>
            <pc:sldMk cId="2456899660" sldId="256"/>
            <ac:grpSpMk id="72" creationId="{1B0721FF-B747-7DEE-EB38-09C449F982BC}"/>
          </ac:grpSpMkLst>
        </pc:grpChg>
        <pc:grpChg chg="add del mod">
          <ac:chgData name="Aiden Hendrickx" userId="b3e63f82dea26a3f" providerId="LiveId" clId="{C5D7819B-D6D1-4CF1-8377-6A023AE00D40}" dt="2024-02-02T10:02:56.488" v="817" actId="165"/>
          <ac:grpSpMkLst>
            <pc:docMk/>
            <pc:sldMk cId="2456899660" sldId="256"/>
            <ac:grpSpMk id="82" creationId="{2147DA15-A16A-759E-F4B9-F54DDA3F0FA9}"/>
          </ac:grpSpMkLst>
        </pc:grpChg>
        <pc:grpChg chg="add mod">
          <ac:chgData name="Aiden Hendrickx" userId="b3e63f82dea26a3f" providerId="LiveId" clId="{C5D7819B-D6D1-4CF1-8377-6A023AE00D40}" dt="2024-02-02T10:04:42.359" v="967" actId="164"/>
          <ac:grpSpMkLst>
            <pc:docMk/>
            <pc:sldMk cId="2456899660" sldId="256"/>
            <ac:grpSpMk id="83" creationId="{09A88BAF-3C1C-CF9F-DEC2-5EF69C17101B}"/>
          </ac:grpSpMkLst>
        </pc:grpChg>
        <pc:grpChg chg="mod">
          <ac:chgData name="Aiden Hendrickx" userId="b3e63f82dea26a3f" providerId="LiveId" clId="{C5D7819B-D6D1-4CF1-8377-6A023AE00D40}" dt="2024-02-02T10:03:01.599" v="818"/>
          <ac:grpSpMkLst>
            <pc:docMk/>
            <pc:sldMk cId="2456899660" sldId="256"/>
            <ac:grpSpMk id="84" creationId="{C71136F3-F6E3-FBAC-77F8-49E37156CB88}"/>
          </ac:grpSpMkLst>
        </pc:grpChg>
        <pc:grpChg chg="add mod">
          <ac:chgData name="Aiden Hendrickx" userId="b3e63f82dea26a3f" providerId="LiveId" clId="{C5D7819B-D6D1-4CF1-8377-6A023AE00D40}" dt="2024-02-02T10:05:54.347" v="1059" actId="1035"/>
          <ac:grpSpMkLst>
            <pc:docMk/>
            <pc:sldMk cId="2456899660" sldId="256"/>
            <ac:grpSpMk id="94" creationId="{277EBA44-819E-00A4-C947-D5FEC3762709}"/>
          </ac:grpSpMkLst>
        </pc:grpChg>
        <pc:grpChg chg="add del mod">
          <ac:chgData name="Aiden Hendrickx" userId="b3e63f82dea26a3f" providerId="LiveId" clId="{C5D7819B-D6D1-4CF1-8377-6A023AE00D40}" dt="2024-02-02T10:05:19.202" v="970" actId="21"/>
          <ac:grpSpMkLst>
            <pc:docMk/>
            <pc:sldMk cId="2456899660" sldId="256"/>
            <ac:grpSpMk id="95" creationId="{382AE4A9-AF2E-DD6C-A448-11F10E7EC6A6}"/>
          </ac:grpSpMkLst>
        </pc:grpChg>
        <pc:grpChg chg="add mod">
          <ac:chgData name="Aiden Hendrickx" userId="b3e63f82dea26a3f" providerId="LiveId" clId="{C5D7819B-D6D1-4CF1-8377-6A023AE00D40}" dt="2024-02-02T10:05:42.029" v="1052" actId="1036"/>
          <ac:grpSpMkLst>
            <pc:docMk/>
            <pc:sldMk cId="2456899660" sldId="256"/>
            <ac:grpSpMk id="96" creationId="{48860674-2B26-4BB3-D127-CEF65154D78B}"/>
          </ac:grpSpMkLst>
        </pc:grpChg>
        <pc:picChg chg="mod">
          <ac:chgData name="Aiden Hendrickx" userId="b3e63f82dea26a3f" providerId="LiveId" clId="{C5D7819B-D6D1-4CF1-8377-6A023AE00D40}" dt="2024-02-02T10:00:05.263" v="470" actId="165"/>
          <ac:picMkLst>
            <pc:docMk/>
            <pc:sldMk cId="2456899660" sldId="256"/>
            <ac:picMk id="5" creationId="{D88A6E01-C2C5-3677-3006-F6F1019631C4}"/>
          </ac:picMkLst>
        </pc:picChg>
        <pc:picChg chg="mod">
          <ac:chgData name="Aiden Hendrickx" userId="b3e63f82dea26a3f" providerId="LiveId" clId="{C5D7819B-D6D1-4CF1-8377-6A023AE00D40}" dt="2024-02-02T10:02:56.488" v="817" actId="165"/>
          <ac:picMkLst>
            <pc:docMk/>
            <pc:sldMk cId="2456899660" sldId="256"/>
            <ac:picMk id="7" creationId="{7AF7EAEA-F78D-48A0-6B3F-FBE2C9FF3E6F}"/>
          </ac:picMkLst>
        </pc:picChg>
        <pc:picChg chg="mod">
          <ac:chgData name="Aiden Hendrickx" userId="b3e63f82dea26a3f" providerId="LiveId" clId="{C5D7819B-D6D1-4CF1-8377-6A023AE00D40}" dt="2024-02-02T10:04:07.054" v="901" actId="1076"/>
          <ac:picMkLst>
            <pc:docMk/>
            <pc:sldMk cId="2456899660" sldId="256"/>
            <ac:picMk id="9" creationId="{CDA26D41-123D-A89E-40D5-225100C392D4}"/>
          </ac:picMkLst>
        </pc:picChg>
        <pc:cxnChg chg="add del mod">
          <ac:chgData name="Aiden Hendrickx" userId="b3e63f82dea26a3f" providerId="LiveId" clId="{C5D7819B-D6D1-4CF1-8377-6A023AE00D40}" dt="2024-02-02T09:43:47.478" v="6" actId="21"/>
          <ac:cxnSpMkLst>
            <pc:docMk/>
            <pc:sldMk cId="2456899660" sldId="256"/>
            <ac:cxnSpMk id="18" creationId="{99F18201-1E45-8CE1-12CF-FACC79F5AEDF}"/>
          </ac:cxnSpMkLst>
        </pc:cxnChg>
        <pc:cxnChg chg="add mod">
          <ac:chgData name="Aiden Hendrickx" userId="b3e63f82dea26a3f" providerId="LiveId" clId="{C5D7819B-D6D1-4CF1-8377-6A023AE00D40}" dt="2024-02-02T10:00:05.263" v="470" actId="165"/>
          <ac:cxnSpMkLst>
            <pc:docMk/>
            <pc:sldMk cId="2456899660" sldId="256"/>
            <ac:cxnSpMk id="23" creationId="{D02EC14C-3F4A-F64F-B3C9-02A5389ABFFF}"/>
          </ac:cxnSpMkLst>
        </pc:cxnChg>
        <pc:cxnChg chg="mod">
          <ac:chgData name="Aiden Hendrickx" userId="b3e63f82dea26a3f" providerId="LiveId" clId="{C5D7819B-D6D1-4CF1-8377-6A023AE00D40}" dt="2024-02-02T09:57:47.316" v="324"/>
          <ac:cxnSpMkLst>
            <pc:docMk/>
            <pc:sldMk cId="2456899660" sldId="256"/>
            <ac:cxnSpMk id="44" creationId="{F52B02DC-D678-3B48-FA40-87E37F5E9DD5}"/>
          </ac:cxnSpMkLst>
        </pc:cxnChg>
        <pc:cxnChg chg="mod">
          <ac:chgData name="Aiden Hendrickx" userId="b3e63f82dea26a3f" providerId="LiveId" clId="{C5D7819B-D6D1-4CF1-8377-6A023AE00D40}" dt="2024-02-02T09:57:47.938" v="325"/>
          <ac:cxnSpMkLst>
            <pc:docMk/>
            <pc:sldMk cId="2456899660" sldId="256"/>
            <ac:cxnSpMk id="55" creationId="{596E6E3C-F797-4969-2B05-B018B9107B5A}"/>
          </ac:cxnSpMkLst>
        </pc:cxnChg>
        <pc:cxnChg chg="mod">
          <ac:chgData name="Aiden Hendrickx" userId="b3e63f82dea26a3f" providerId="LiveId" clId="{C5D7819B-D6D1-4CF1-8377-6A023AE00D40}" dt="2024-02-02T10:02:12.752" v="808" actId="164"/>
          <ac:cxnSpMkLst>
            <pc:docMk/>
            <pc:sldMk cId="2456899660" sldId="256"/>
            <ac:cxnSpMk id="67" creationId="{19AFAA10-DCF6-80AD-98F4-EBE3AB0C4DB7}"/>
          </ac:cxnSpMkLst>
        </pc:cxnChg>
        <pc:cxnChg chg="mod">
          <ac:chgData name="Aiden Hendrickx" userId="b3e63f82dea26a3f" providerId="LiveId" clId="{C5D7819B-D6D1-4CF1-8377-6A023AE00D40}" dt="2024-02-02T10:02:56.488" v="817" actId="165"/>
          <ac:cxnSpMkLst>
            <pc:docMk/>
            <pc:sldMk cId="2456899660" sldId="256"/>
            <ac:cxnSpMk id="79" creationId="{426EA881-CAB8-1CE2-5B70-3E7B5301747A}"/>
          </ac:cxnSpMkLst>
        </pc:cxnChg>
        <pc:cxnChg chg="mod">
          <ac:chgData name="Aiden Hendrickx" userId="b3e63f82dea26a3f" providerId="LiveId" clId="{C5D7819B-D6D1-4CF1-8377-6A023AE00D40}" dt="2024-02-02T10:03:01.599" v="818"/>
          <ac:cxnSpMkLst>
            <pc:docMk/>
            <pc:sldMk cId="2456899660" sldId="256"/>
            <ac:cxnSpMk id="91" creationId="{4A9A6009-3FB1-AD45-1EE7-066296436B40}"/>
          </ac:cxnSpMkLst>
        </pc:cxnChg>
      </pc:sldChg>
      <pc:sldChg chg="addSp delSp modSp mod">
        <pc:chgData name="Aiden Hendrickx" userId="b3e63f82dea26a3f" providerId="LiveId" clId="{C5D7819B-D6D1-4CF1-8377-6A023AE00D40}" dt="2024-02-02T10:11:25.193" v="1219" actId="1035"/>
        <pc:sldMkLst>
          <pc:docMk/>
          <pc:sldMk cId="2958301584" sldId="257"/>
        </pc:sldMkLst>
        <pc:spChg chg="mod">
          <ac:chgData name="Aiden Hendrickx" userId="b3e63f82dea26a3f" providerId="LiveId" clId="{C5D7819B-D6D1-4CF1-8377-6A023AE00D40}" dt="2024-02-02T10:06:15.117" v="1061" actId="165"/>
          <ac:spMkLst>
            <pc:docMk/>
            <pc:sldMk cId="2958301584" sldId="257"/>
            <ac:spMk id="2" creationId="{AEAF22E7-11F8-FF93-3FB5-65E44E54C8E7}"/>
          </ac:spMkLst>
        </pc:spChg>
        <pc:spChg chg="mod">
          <ac:chgData name="Aiden Hendrickx" userId="b3e63f82dea26a3f" providerId="LiveId" clId="{C5D7819B-D6D1-4CF1-8377-6A023AE00D40}" dt="2024-02-02T10:06:15.117" v="1061" actId="165"/>
          <ac:spMkLst>
            <pc:docMk/>
            <pc:sldMk cId="2958301584" sldId="257"/>
            <ac:spMk id="6" creationId="{2B14BC77-5320-0BF1-C52B-F1BDB7212F57}"/>
          </ac:spMkLst>
        </pc:spChg>
        <pc:spChg chg="mod">
          <ac:chgData name="Aiden Hendrickx" userId="b3e63f82dea26a3f" providerId="LiveId" clId="{C5D7819B-D6D1-4CF1-8377-6A023AE00D40}" dt="2024-02-02T10:10:19.574" v="1209" actId="165"/>
          <ac:spMkLst>
            <pc:docMk/>
            <pc:sldMk cId="2958301584" sldId="257"/>
            <ac:spMk id="8" creationId="{A256FD77-3752-71F6-29C5-4DD2BA744BF0}"/>
          </ac:spMkLst>
        </pc:spChg>
        <pc:spChg chg="mod">
          <ac:chgData name="Aiden Hendrickx" userId="b3e63f82dea26a3f" providerId="LiveId" clId="{C5D7819B-D6D1-4CF1-8377-6A023AE00D40}" dt="2024-02-02T10:08:08.419" v="1184"/>
          <ac:spMkLst>
            <pc:docMk/>
            <pc:sldMk cId="2958301584" sldId="257"/>
            <ac:spMk id="14" creationId="{5F0CA641-E98A-36EE-1FA3-AC3FAA54DACE}"/>
          </ac:spMkLst>
        </pc:spChg>
        <pc:spChg chg="mod">
          <ac:chgData name="Aiden Hendrickx" userId="b3e63f82dea26a3f" providerId="LiveId" clId="{C5D7819B-D6D1-4CF1-8377-6A023AE00D40}" dt="2024-02-02T10:08:08.419" v="1184"/>
          <ac:spMkLst>
            <pc:docMk/>
            <pc:sldMk cId="2958301584" sldId="257"/>
            <ac:spMk id="15" creationId="{5B781C6D-CDAF-472F-3E70-509569D83E45}"/>
          </ac:spMkLst>
        </pc:spChg>
        <pc:spChg chg="mod">
          <ac:chgData name="Aiden Hendrickx" userId="b3e63f82dea26a3f" providerId="LiveId" clId="{C5D7819B-D6D1-4CF1-8377-6A023AE00D40}" dt="2024-02-02T10:08:08.419" v="1184"/>
          <ac:spMkLst>
            <pc:docMk/>
            <pc:sldMk cId="2958301584" sldId="257"/>
            <ac:spMk id="16" creationId="{0C59E46B-80F4-BEA9-901C-98E81510C12D}"/>
          </ac:spMkLst>
        </pc:spChg>
        <pc:spChg chg="mod">
          <ac:chgData name="Aiden Hendrickx" userId="b3e63f82dea26a3f" providerId="LiveId" clId="{C5D7819B-D6D1-4CF1-8377-6A023AE00D40}" dt="2024-02-02T10:08:08.419" v="1184"/>
          <ac:spMkLst>
            <pc:docMk/>
            <pc:sldMk cId="2958301584" sldId="257"/>
            <ac:spMk id="17" creationId="{8A18DF84-BAB1-70AC-E452-CF9A10B89125}"/>
          </ac:spMkLst>
        </pc:spChg>
        <pc:spChg chg="mod">
          <ac:chgData name="Aiden Hendrickx" userId="b3e63f82dea26a3f" providerId="LiveId" clId="{C5D7819B-D6D1-4CF1-8377-6A023AE00D40}" dt="2024-02-02T10:08:08.419" v="1184"/>
          <ac:spMkLst>
            <pc:docMk/>
            <pc:sldMk cId="2958301584" sldId="257"/>
            <ac:spMk id="18" creationId="{B97773CC-0A8A-6D4C-DB98-F71005D8D576}"/>
          </ac:spMkLst>
        </pc:spChg>
        <pc:spChg chg="mod">
          <ac:chgData name="Aiden Hendrickx" userId="b3e63f82dea26a3f" providerId="LiveId" clId="{C5D7819B-D6D1-4CF1-8377-6A023AE00D40}" dt="2024-02-02T10:08:08.419" v="1184"/>
          <ac:spMkLst>
            <pc:docMk/>
            <pc:sldMk cId="2958301584" sldId="257"/>
            <ac:spMk id="19" creationId="{AB1B1EAD-B1B4-B652-3AD6-5D8E13E65C92}"/>
          </ac:spMkLst>
        </pc:spChg>
        <pc:spChg chg="mod">
          <ac:chgData name="Aiden Hendrickx" userId="b3e63f82dea26a3f" providerId="LiveId" clId="{C5D7819B-D6D1-4CF1-8377-6A023AE00D40}" dt="2024-02-02T10:08:08.419" v="1184"/>
          <ac:spMkLst>
            <pc:docMk/>
            <pc:sldMk cId="2958301584" sldId="257"/>
            <ac:spMk id="21" creationId="{17057702-376B-F547-8C43-8B6ED06CEFA1}"/>
          </ac:spMkLst>
        </pc:spChg>
        <pc:spChg chg="mod">
          <ac:chgData name="Aiden Hendrickx" userId="b3e63f82dea26a3f" providerId="LiveId" clId="{C5D7819B-D6D1-4CF1-8377-6A023AE00D40}" dt="2024-02-02T10:08:08.419" v="1184"/>
          <ac:spMkLst>
            <pc:docMk/>
            <pc:sldMk cId="2958301584" sldId="257"/>
            <ac:spMk id="22" creationId="{38EF9DA5-6612-EDE9-1395-809DE80B9775}"/>
          </ac:spMkLst>
        </pc:spChg>
        <pc:spChg chg="mod">
          <ac:chgData name="Aiden Hendrickx" userId="b3e63f82dea26a3f" providerId="LiveId" clId="{C5D7819B-D6D1-4CF1-8377-6A023AE00D40}" dt="2024-02-02T10:10:19.574" v="1209" actId="165"/>
          <ac:spMkLst>
            <pc:docMk/>
            <pc:sldMk cId="2958301584" sldId="257"/>
            <ac:spMk id="25" creationId="{E7AD342E-18A8-DDDD-92EB-7639AB22B518}"/>
          </ac:spMkLst>
        </pc:spChg>
        <pc:spChg chg="mod">
          <ac:chgData name="Aiden Hendrickx" userId="b3e63f82dea26a3f" providerId="LiveId" clId="{C5D7819B-D6D1-4CF1-8377-6A023AE00D40}" dt="2024-02-02T10:10:19.574" v="1209" actId="165"/>
          <ac:spMkLst>
            <pc:docMk/>
            <pc:sldMk cId="2958301584" sldId="257"/>
            <ac:spMk id="26" creationId="{89151E0F-2A5A-3B46-5801-91F919DD16ED}"/>
          </ac:spMkLst>
        </pc:spChg>
        <pc:spChg chg="mod">
          <ac:chgData name="Aiden Hendrickx" userId="b3e63f82dea26a3f" providerId="LiveId" clId="{C5D7819B-D6D1-4CF1-8377-6A023AE00D40}" dt="2024-02-02T10:10:19.574" v="1209" actId="165"/>
          <ac:spMkLst>
            <pc:docMk/>
            <pc:sldMk cId="2958301584" sldId="257"/>
            <ac:spMk id="27" creationId="{2AF4595C-9E57-6AB2-C8B8-8D877D6C69FC}"/>
          </ac:spMkLst>
        </pc:spChg>
        <pc:spChg chg="mod">
          <ac:chgData name="Aiden Hendrickx" userId="b3e63f82dea26a3f" providerId="LiveId" clId="{C5D7819B-D6D1-4CF1-8377-6A023AE00D40}" dt="2024-02-02T10:10:19.574" v="1209" actId="165"/>
          <ac:spMkLst>
            <pc:docMk/>
            <pc:sldMk cId="2958301584" sldId="257"/>
            <ac:spMk id="28" creationId="{3DE4057D-33AE-962F-C0D3-560E4E633624}"/>
          </ac:spMkLst>
        </pc:spChg>
        <pc:spChg chg="mod">
          <ac:chgData name="Aiden Hendrickx" userId="b3e63f82dea26a3f" providerId="LiveId" clId="{C5D7819B-D6D1-4CF1-8377-6A023AE00D40}" dt="2024-02-02T10:10:19.574" v="1209" actId="165"/>
          <ac:spMkLst>
            <pc:docMk/>
            <pc:sldMk cId="2958301584" sldId="257"/>
            <ac:spMk id="29" creationId="{FE242BEC-8797-64DB-5185-A0F671F794E6}"/>
          </ac:spMkLst>
        </pc:spChg>
        <pc:spChg chg="mod">
          <ac:chgData name="Aiden Hendrickx" userId="b3e63f82dea26a3f" providerId="LiveId" clId="{C5D7819B-D6D1-4CF1-8377-6A023AE00D40}" dt="2024-02-02T10:10:19.574" v="1209" actId="165"/>
          <ac:spMkLst>
            <pc:docMk/>
            <pc:sldMk cId="2958301584" sldId="257"/>
            <ac:spMk id="30" creationId="{39A9B7F9-83DE-6668-4A24-DB0EFE3935FF}"/>
          </ac:spMkLst>
        </pc:spChg>
        <pc:spChg chg="mod">
          <ac:chgData name="Aiden Hendrickx" userId="b3e63f82dea26a3f" providerId="LiveId" clId="{C5D7819B-D6D1-4CF1-8377-6A023AE00D40}" dt="2024-02-02T10:10:19.574" v="1209" actId="165"/>
          <ac:spMkLst>
            <pc:docMk/>
            <pc:sldMk cId="2958301584" sldId="257"/>
            <ac:spMk id="32" creationId="{388F499C-9994-EF07-C83B-7B61E8F4FD64}"/>
          </ac:spMkLst>
        </pc:spChg>
        <pc:spChg chg="mod">
          <ac:chgData name="Aiden Hendrickx" userId="b3e63f82dea26a3f" providerId="LiveId" clId="{C5D7819B-D6D1-4CF1-8377-6A023AE00D40}" dt="2024-02-02T10:10:19.574" v="1209" actId="165"/>
          <ac:spMkLst>
            <pc:docMk/>
            <pc:sldMk cId="2958301584" sldId="257"/>
            <ac:spMk id="33" creationId="{ADBAB8F3-90FE-1DEB-273C-D5FDD0E36E02}"/>
          </ac:spMkLst>
        </pc:spChg>
        <pc:grpChg chg="add mod">
          <ac:chgData name="Aiden Hendrickx" userId="b3e63f82dea26a3f" providerId="LiveId" clId="{C5D7819B-D6D1-4CF1-8377-6A023AE00D40}" dt="2024-02-02T10:10:37.377" v="1214" actId="164"/>
          <ac:grpSpMkLst>
            <pc:docMk/>
            <pc:sldMk cId="2958301584" sldId="257"/>
            <ac:grpSpMk id="3" creationId="{CF5AF131-17E4-7CCC-A0F4-17673AF71D9B}"/>
          </ac:grpSpMkLst>
        </pc:grpChg>
        <pc:grpChg chg="mod">
          <ac:chgData name="Aiden Hendrickx" userId="b3e63f82dea26a3f" providerId="LiveId" clId="{C5D7819B-D6D1-4CF1-8377-6A023AE00D40}" dt="2024-02-02T10:08:08.419" v="1184"/>
          <ac:grpSpMkLst>
            <pc:docMk/>
            <pc:sldMk cId="2958301584" sldId="257"/>
            <ac:grpSpMk id="4" creationId="{02141ECD-5E65-9089-AD75-F8041F5C0DAC}"/>
          </ac:grpSpMkLst>
        </pc:grpChg>
        <pc:grpChg chg="del mod topLvl">
          <ac:chgData name="Aiden Hendrickx" userId="b3e63f82dea26a3f" providerId="LiveId" clId="{C5D7819B-D6D1-4CF1-8377-6A023AE00D40}" dt="2024-02-02T10:06:17.337" v="1062" actId="21"/>
          <ac:grpSpMkLst>
            <pc:docMk/>
            <pc:sldMk cId="2958301584" sldId="257"/>
            <ac:grpSpMk id="5" creationId="{8C68F958-635D-4CD4-A0FC-D9613CD14158}"/>
          </ac:grpSpMkLst>
        </pc:grpChg>
        <pc:grpChg chg="mod topLvl">
          <ac:chgData name="Aiden Hendrickx" userId="b3e63f82dea26a3f" providerId="LiveId" clId="{C5D7819B-D6D1-4CF1-8377-6A023AE00D40}" dt="2024-02-02T10:10:43.231" v="1215" actId="164"/>
          <ac:grpSpMkLst>
            <pc:docMk/>
            <pc:sldMk cId="2958301584" sldId="257"/>
            <ac:grpSpMk id="10" creationId="{69DA5AFD-DF2F-2E55-73A4-5FA5844EF3EA}"/>
          </ac:grpSpMkLst>
        </pc:grpChg>
        <pc:grpChg chg="mod topLvl">
          <ac:chgData name="Aiden Hendrickx" userId="b3e63f82dea26a3f" providerId="LiveId" clId="{C5D7819B-D6D1-4CF1-8377-6A023AE00D40}" dt="2024-02-02T10:10:37.377" v="1214" actId="164"/>
          <ac:grpSpMkLst>
            <pc:docMk/>
            <pc:sldMk cId="2958301584" sldId="257"/>
            <ac:grpSpMk id="12" creationId="{C17280ED-A1D4-485A-2170-974934B41B7F}"/>
          </ac:grpSpMkLst>
        </pc:grpChg>
        <pc:grpChg chg="del">
          <ac:chgData name="Aiden Hendrickx" userId="b3e63f82dea26a3f" providerId="LiveId" clId="{C5D7819B-D6D1-4CF1-8377-6A023AE00D40}" dt="2024-02-02T10:06:15.117" v="1061" actId="165"/>
          <ac:grpSpMkLst>
            <pc:docMk/>
            <pc:sldMk cId="2958301584" sldId="257"/>
            <ac:grpSpMk id="13" creationId="{C8E8A90F-7C77-DD4F-6EED-600D730977E0}"/>
          </ac:grpSpMkLst>
        </pc:grpChg>
        <pc:grpChg chg="add mod topLvl">
          <ac:chgData name="Aiden Hendrickx" userId="b3e63f82dea26a3f" providerId="LiveId" clId="{C5D7819B-D6D1-4CF1-8377-6A023AE00D40}" dt="2024-02-02T10:10:43.231" v="1215" actId="164"/>
          <ac:grpSpMkLst>
            <pc:docMk/>
            <pc:sldMk cId="2958301584" sldId="257"/>
            <ac:grpSpMk id="23" creationId="{1C628CC9-47D3-5F56-DDC9-4CFCA8EEBDC9}"/>
          </ac:grpSpMkLst>
        </pc:grpChg>
        <pc:grpChg chg="mod">
          <ac:chgData name="Aiden Hendrickx" userId="b3e63f82dea26a3f" providerId="LiveId" clId="{C5D7819B-D6D1-4CF1-8377-6A023AE00D40}" dt="2024-02-02T10:10:19.574" v="1209" actId="165"/>
          <ac:grpSpMkLst>
            <pc:docMk/>
            <pc:sldMk cId="2958301584" sldId="257"/>
            <ac:grpSpMk id="24" creationId="{21B12948-80DA-9960-C7BD-7727783E4223}"/>
          </ac:grpSpMkLst>
        </pc:grpChg>
        <pc:grpChg chg="add del mod">
          <ac:chgData name="Aiden Hendrickx" userId="b3e63f82dea26a3f" providerId="LiveId" clId="{C5D7819B-D6D1-4CF1-8377-6A023AE00D40}" dt="2024-02-02T10:10:19.574" v="1209" actId="165"/>
          <ac:grpSpMkLst>
            <pc:docMk/>
            <pc:sldMk cId="2958301584" sldId="257"/>
            <ac:grpSpMk id="34" creationId="{79068066-D651-8ED9-F5F6-5493116B382D}"/>
          </ac:grpSpMkLst>
        </pc:grpChg>
        <pc:grpChg chg="add mod">
          <ac:chgData name="Aiden Hendrickx" userId="b3e63f82dea26a3f" providerId="LiveId" clId="{C5D7819B-D6D1-4CF1-8377-6A023AE00D40}" dt="2024-02-02T10:10:37.377" v="1214" actId="164"/>
          <ac:grpSpMkLst>
            <pc:docMk/>
            <pc:sldMk cId="2958301584" sldId="257"/>
            <ac:grpSpMk id="35" creationId="{646023AA-C002-3D1F-D19D-74A7D9A4A5E4}"/>
          </ac:grpSpMkLst>
        </pc:grpChg>
        <pc:grpChg chg="add mod">
          <ac:chgData name="Aiden Hendrickx" userId="b3e63f82dea26a3f" providerId="LiveId" clId="{C5D7819B-D6D1-4CF1-8377-6A023AE00D40}" dt="2024-02-02T10:11:25.193" v="1219" actId="1035"/>
          <ac:grpSpMkLst>
            <pc:docMk/>
            <pc:sldMk cId="2958301584" sldId="257"/>
            <ac:grpSpMk id="36" creationId="{0E112B6C-24E1-1076-A8C5-152A96B56A4B}"/>
          </ac:grpSpMkLst>
        </pc:grpChg>
        <pc:picChg chg="mod">
          <ac:chgData name="Aiden Hendrickx" userId="b3e63f82dea26a3f" providerId="LiveId" clId="{C5D7819B-D6D1-4CF1-8377-6A023AE00D40}" dt="2024-02-02T10:06:15.117" v="1061" actId="165"/>
          <ac:picMkLst>
            <pc:docMk/>
            <pc:sldMk cId="2958301584" sldId="257"/>
            <ac:picMk id="7" creationId="{F90E480B-A126-5DED-58CC-6476F989A488}"/>
          </ac:picMkLst>
        </pc:picChg>
        <pc:picChg chg="mod">
          <ac:chgData name="Aiden Hendrickx" userId="b3e63f82dea26a3f" providerId="LiveId" clId="{C5D7819B-D6D1-4CF1-8377-6A023AE00D40}" dt="2024-02-02T10:06:15.117" v="1061" actId="165"/>
          <ac:picMkLst>
            <pc:docMk/>
            <pc:sldMk cId="2958301584" sldId="257"/>
            <ac:picMk id="9" creationId="{1C083552-1882-BF19-74F4-C123E2080A3B}"/>
          </ac:picMkLst>
        </pc:picChg>
        <pc:picChg chg="mod">
          <ac:chgData name="Aiden Hendrickx" userId="b3e63f82dea26a3f" providerId="LiveId" clId="{C5D7819B-D6D1-4CF1-8377-6A023AE00D40}" dt="2024-02-02T10:10:19.574" v="1209" actId="165"/>
          <ac:picMkLst>
            <pc:docMk/>
            <pc:sldMk cId="2958301584" sldId="257"/>
            <ac:picMk id="11" creationId="{AC7AED7A-B796-9B46-8865-60A923CB111D}"/>
          </ac:picMkLst>
        </pc:picChg>
        <pc:cxnChg chg="mod">
          <ac:chgData name="Aiden Hendrickx" userId="b3e63f82dea26a3f" providerId="LiveId" clId="{C5D7819B-D6D1-4CF1-8377-6A023AE00D40}" dt="2024-02-02T10:08:08.419" v="1184"/>
          <ac:cxnSpMkLst>
            <pc:docMk/>
            <pc:sldMk cId="2958301584" sldId="257"/>
            <ac:cxnSpMk id="20" creationId="{AE5D0B87-FFF9-21B5-31D1-7B31F5AA73A4}"/>
          </ac:cxnSpMkLst>
        </pc:cxnChg>
        <pc:cxnChg chg="mod">
          <ac:chgData name="Aiden Hendrickx" userId="b3e63f82dea26a3f" providerId="LiveId" clId="{C5D7819B-D6D1-4CF1-8377-6A023AE00D40}" dt="2024-02-02T10:10:19.574" v="1209" actId="165"/>
          <ac:cxnSpMkLst>
            <pc:docMk/>
            <pc:sldMk cId="2958301584" sldId="257"/>
            <ac:cxnSpMk id="31" creationId="{825A7319-7F43-F7F6-CF7F-3C32CE49686E}"/>
          </ac:cxnSpMkLst>
        </pc:cxnChg>
      </pc:sldChg>
      <pc:sldChg chg="addSp delSp modSp new del mod">
        <pc:chgData name="Aiden Hendrickx" userId="b3e63f82dea26a3f" providerId="LiveId" clId="{C5D7819B-D6D1-4CF1-8377-6A023AE00D40}" dt="2024-02-02T10:11:49.378" v="1223" actId="47"/>
        <pc:sldMkLst>
          <pc:docMk/>
          <pc:sldMk cId="3625568874" sldId="258"/>
        </pc:sldMkLst>
        <pc:spChg chg="del">
          <ac:chgData name="Aiden Hendrickx" userId="b3e63f82dea26a3f" providerId="LiveId" clId="{C5D7819B-D6D1-4CF1-8377-6A023AE00D40}" dt="2024-02-02T09:43:51.482" v="8" actId="478"/>
          <ac:spMkLst>
            <pc:docMk/>
            <pc:sldMk cId="3625568874" sldId="258"/>
            <ac:spMk id="2" creationId="{2F7FEF00-1C00-6E2A-0B8F-F2734753EA48}"/>
          </ac:spMkLst>
        </pc:spChg>
        <pc:spChg chg="del">
          <ac:chgData name="Aiden Hendrickx" userId="b3e63f82dea26a3f" providerId="LiveId" clId="{C5D7819B-D6D1-4CF1-8377-6A023AE00D40}" dt="2024-02-02T09:43:51.482" v="8" actId="478"/>
          <ac:spMkLst>
            <pc:docMk/>
            <pc:sldMk cId="3625568874" sldId="258"/>
            <ac:spMk id="3" creationId="{4D9768C3-7237-D98A-EF4D-2591FC3223B0}"/>
          </ac:spMkLst>
        </pc:spChg>
        <pc:spChg chg="add mod">
          <ac:chgData name="Aiden Hendrickx" userId="b3e63f82dea26a3f" providerId="LiveId" clId="{C5D7819B-D6D1-4CF1-8377-6A023AE00D40}" dt="2024-02-02T09:43:54.891" v="10" actId="1076"/>
          <ac:spMkLst>
            <pc:docMk/>
            <pc:sldMk cId="3625568874" sldId="258"/>
            <ac:spMk id="4" creationId="{5FFCEC1F-25EC-508A-68F7-38E933843F66}"/>
          </ac:spMkLst>
        </pc:spChg>
        <pc:spChg chg="add mod">
          <ac:chgData name="Aiden Hendrickx" userId="b3e63f82dea26a3f" providerId="LiveId" clId="{C5D7819B-D6D1-4CF1-8377-6A023AE00D40}" dt="2024-02-02T09:45:15.108" v="22"/>
          <ac:spMkLst>
            <pc:docMk/>
            <pc:sldMk cId="3625568874" sldId="258"/>
            <ac:spMk id="5" creationId="{4ABD0B06-1BEA-34FC-0C28-6EF44D32586E}"/>
          </ac:spMkLst>
        </pc:spChg>
        <pc:spChg chg="add mod">
          <ac:chgData name="Aiden Hendrickx" userId="b3e63f82dea26a3f" providerId="LiveId" clId="{C5D7819B-D6D1-4CF1-8377-6A023AE00D40}" dt="2024-02-02T09:43:54.891" v="10" actId="1076"/>
          <ac:spMkLst>
            <pc:docMk/>
            <pc:sldMk cId="3625568874" sldId="258"/>
            <ac:spMk id="13" creationId="{705E5F52-BF4C-C293-A585-0B43CA7AFE6A}"/>
          </ac:spMkLst>
        </pc:spChg>
        <pc:spChg chg="add del mod">
          <ac:chgData name="Aiden Hendrickx" userId="b3e63f82dea26a3f" providerId="LiveId" clId="{C5D7819B-D6D1-4CF1-8377-6A023AE00D40}" dt="2024-02-02T09:45:05.378" v="21" actId="21"/>
          <ac:spMkLst>
            <pc:docMk/>
            <pc:sldMk cId="3625568874" sldId="258"/>
            <ac:spMk id="14" creationId="{4ABD0B06-1BEA-34FC-0C28-6EF44D32586E}"/>
          </ac:spMkLst>
        </pc:spChg>
        <pc:spChg chg="add del mod">
          <ac:chgData name="Aiden Hendrickx" userId="b3e63f82dea26a3f" providerId="LiveId" clId="{C5D7819B-D6D1-4CF1-8377-6A023AE00D40}" dt="2024-02-02T09:44:13.778" v="13" actId="21"/>
          <ac:spMkLst>
            <pc:docMk/>
            <pc:sldMk cId="3625568874" sldId="258"/>
            <ac:spMk id="15" creationId="{27E23BDF-E4F2-8BFC-21A3-D07E3F48E163}"/>
          </ac:spMkLst>
        </pc:spChg>
        <pc:spChg chg="add del mod">
          <ac:chgData name="Aiden Hendrickx" userId="b3e63f82dea26a3f" providerId="LiveId" clId="{C5D7819B-D6D1-4CF1-8377-6A023AE00D40}" dt="2024-02-02T09:44:03.550" v="12" actId="478"/>
          <ac:spMkLst>
            <pc:docMk/>
            <pc:sldMk cId="3625568874" sldId="258"/>
            <ac:spMk id="16" creationId="{D43E8269-EA9D-7243-A227-914AED581729}"/>
          </ac:spMkLst>
        </pc:spChg>
        <pc:spChg chg="add del mod">
          <ac:chgData name="Aiden Hendrickx" userId="b3e63f82dea26a3f" providerId="LiveId" clId="{C5D7819B-D6D1-4CF1-8377-6A023AE00D40}" dt="2024-02-02T09:43:59.630" v="11" actId="478"/>
          <ac:spMkLst>
            <pc:docMk/>
            <pc:sldMk cId="3625568874" sldId="258"/>
            <ac:spMk id="17" creationId="{BE1AECCE-E9E8-FD34-B36E-398E046F959B}"/>
          </ac:spMkLst>
        </pc:spChg>
        <pc:cxnChg chg="add mod">
          <ac:chgData name="Aiden Hendrickx" userId="b3e63f82dea26a3f" providerId="LiveId" clId="{C5D7819B-D6D1-4CF1-8377-6A023AE00D40}" dt="2024-02-02T09:45:15.108" v="22"/>
          <ac:cxnSpMkLst>
            <pc:docMk/>
            <pc:sldMk cId="3625568874" sldId="258"/>
            <ac:cxnSpMk id="6" creationId="{99F18201-1E45-8CE1-12CF-FACC79F5AEDF}"/>
          </ac:cxnSpMkLst>
        </pc:cxnChg>
        <pc:cxnChg chg="add del mod">
          <ac:chgData name="Aiden Hendrickx" userId="b3e63f82dea26a3f" providerId="LiveId" clId="{C5D7819B-D6D1-4CF1-8377-6A023AE00D40}" dt="2024-02-02T09:45:05.378" v="21" actId="21"/>
          <ac:cxnSpMkLst>
            <pc:docMk/>
            <pc:sldMk cId="3625568874" sldId="258"/>
            <ac:cxnSpMk id="18" creationId="{99F18201-1E45-8CE1-12CF-FACC79F5AEDF}"/>
          </ac:cxnSpMkLst>
        </pc:cxnChg>
      </pc:sldChg>
      <pc:sldChg chg="addSp delSp modSp new mod">
        <pc:chgData name="Aiden Hendrickx" userId="b3e63f82dea26a3f" providerId="LiveId" clId="{C5D7819B-D6D1-4CF1-8377-6A023AE00D40}" dt="2024-02-02T10:11:41.144" v="1222" actId="1076"/>
        <pc:sldMkLst>
          <pc:docMk/>
          <pc:sldMk cId="249257487" sldId="259"/>
        </pc:sldMkLst>
        <pc:spChg chg="del">
          <ac:chgData name="Aiden Hendrickx" userId="b3e63f82dea26a3f" providerId="LiveId" clId="{C5D7819B-D6D1-4CF1-8377-6A023AE00D40}" dt="2024-02-02T10:05:10.139" v="969" actId="478"/>
          <ac:spMkLst>
            <pc:docMk/>
            <pc:sldMk cId="249257487" sldId="259"/>
            <ac:spMk id="2" creationId="{CC9574CC-6CF8-2E32-021C-5155D89DDE2C}"/>
          </ac:spMkLst>
        </pc:spChg>
        <pc:spChg chg="del">
          <ac:chgData name="Aiden Hendrickx" userId="b3e63f82dea26a3f" providerId="LiveId" clId="{C5D7819B-D6D1-4CF1-8377-6A023AE00D40}" dt="2024-02-02T10:05:10.139" v="969" actId="478"/>
          <ac:spMkLst>
            <pc:docMk/>
            <pc:sldMk cId="249257487" sldId="259"/>
            <ac:spMk id="3" creationId="{4FEC4873-60BD-F412-187B-828B7C309712}"/>
          </ac:spMkLst>
        </pc:spChg>
        <pc:spChg chg="mod">
          <ac:chgData name="Aiden Hendrickx" userId="b3e63f82dea26a3f" providerId="LiveId" clId="{C5D7819B-D6D1-4CF1-8377-6A023AE00D40}" dt="2024-02-02T10:06:19.614" v="1063"/>
          <ac:spMkLst>
            <pc:docMk/>
            <pc:sldMk cId="249257487" sldId="259"/>
            <ac:spMk id="4" creationId="{AEAF22E7-11F8-FF93-3FB5-65E44E54C8E7}"/>
          </ac:spMkLst>
        </pc:spChg>
        <pc:spChg chg="mod">
          <ac:chgData name="Aiden Hendrickx" userId="b3e63f82dea26a3f" providerId="LiveId" clId="{C5D7819B-D6D1-4CF1-8377-6A023AE00D40}" dt="2024-02-02T10:06:43.363" v="1066" actId="165"/>
          <ac:spMkLst>
            <pc:docMk/>
            <pc:sldMk cId="249257487" sldId="259"/>
            <ac:spMk id="10" creationId="{9E9D8DCC-D327-53A1-7D2E-5C968117600C}"/>
          </ac:spMkLst>
        </pc:spChg>
        <pc:spChg chg="mod">
          <ac:chgData name="Aiden Hendrickx" userId="b3e63f82dea26a3f" providerId="LiveId" clId="{C5D7819B-D6D1-4CF1-8377-6A023AE00D40}" dt="2024-02-02T10:06:48.868" v="1067"/>
          <ac:spMkLst>
            <pc:docMk/>
            <pc:sldMk cId="249257487" sldId="259"/>
            <ac:spMk id="12" creationId="{CCA1CBE5-6DB4-6ED7-E449-483E962781E1}"/>
          </ac:spMkLst>
        </pc:spChg>
        <pc:spChg chg="mod">
          <ac:chgData name="Aiden Hendrickx" userId="b3e63f82dea26a3f" providerId="LiveId" clId="{C5D7819B-D6D1-4CF1-8377-6A023AE00D40}" dt="2024-02-02T10:06:48.868" v="1067"/>
          <ac:spMkLst>
            <pc:docMk/>
            <pc:sldMk cId="249257487" sldId="259"/>
            <ac:spMk id="13" creationId="{B7D8E555-8DB6-10D8-CC61-836A675726EA}"/>
          </ac:spMkLst>
        </pc:spChg>
        <pc:spChg chg="mod">
          <ac:chgData name="Aiden Hendrickx" userId="b3e63f82dea26a3f" providerId="LiveId" clId="{C5D7819B-D6D1-4CF1-8377-6A023AE00D40}" dt="2024-02-02T10:06:48.868" v="1067"/>
          <ac:spMkLst>
            <pc:docMk/>
            <pc:sldMk cId="249257487" sldId="259"/>
            <ac:spMk id="14" creationId="{25B55700-E48E-EE4D-B183-4E5EE12FD867}"/>
          </ac:spMkLst>
        </pc:spChg>
        <pc:spChg chg="mod">
          <ac:chgData name="Aiden Hendrickx" userId="b3e63f82dea26a3f" providerId="LiveId" clId="{C5D7819B-D6D1-4CF1-8377-6A023AE00D40}" dt="2024-02-02T10:06:48.868" v="1067"/>
          <ac:spMkLst>
            <pc:docMk/>
            <pc:sldMk cId="249257487" sldId="259"/>
            <ac:spMk id="15" creationId="{2221B124-C724-68D5-3D65-43899156CD44}"/>
          </ac:spMkLst>
        </pc:spChg>
        <pc:spChg chg="mod">
          <ac:chgData name="Aiden Hendrickx" userId="b3e63f82dea26a3f" providerId="LiveId" clId="{C5D7819B-D6D1-4CF1-8377-6A023AE00D40}" dt="2024-02-02T10:06:48.868" v="1067"/>
          <ac:spMkLst>
            <pc:docMk/>
            <pc:sldMk cId="249257487" sldId="259"/>
            <ac:spMk id="16" creationId="{388DEF91-E319-373B-77A5-6D1CC70C5E13}"/>
          </ac:spMkLst>
        </pc:spChg>
        <pc:spChg chg="mod">
          <ac:chgData name="Aiden Hendrickx" userId="b3e63f82dea26a3f" providerId="LiveId" clId="{C5D7819B-D6D1-4CF1-8377-6A023AE00D40}" dt="2024-02-02T10:06:48.868" v="1067"/>
          <ac:spMkLst>
            <pc:docMk/>
            <pc:sldMk cId="249257487" sldId="259"/>
            <ac:spMk id="17" creationId="{805D6951-146D-9BD4-1296-ED552FD2E6DD}"/>
          </ac:spMkLst>
        </pc:spChg>
        <pc:spChg chg="mod">
          <ac:chgData name="Aiden Hendrickx" userId="b3e63f82dea26a3f" providerId="LiveId" clId="{C5D7819B-D6D1-4CF1-8377-6A023AE00D40}" dt="2024-02-02T10:06:48.868" v="1067"/>
          <ac:spMkLst>
            <pc:docMk/>
            <pc:sldMk cId="249257487" sldId="259"/>
            <ac:spMk id="19" creationId="{9542B06C-C6C3-DD8E-7A71-4E074459E103}"/>
          </ac:spMkLst>
        </pc:spChg>
        <pc:spChg chg="mod">
          <ac:chgData name="Aiden Hendrickx" userId="b3e63f82dea26a3f" providerId="LiveId" clId="{C5D7819B-D6D1-4CF1-8377-6A023AE00D40}" dt="2024-02-02T10:06:48.868" v="1067"/>
          <ac:spMkLst>
            <pc:docMk/>
            <pc:sldMk cId="249257487" sldId="259"/>
            <ac:spMk id="20" creationId="{45A25862-FB3D-5E44-DF61-6B4AEF9C2140}"/>
          </ac:spMkLst>
        </pc:spChg>
        <pc:spChg chg="mod">
          <ac:chgData name="Aiden Hendrickx" userId="b3e63f82dea26a3f" providerId="LiveId" clId="{C5D7819B-D6D1-4CF1-8377-6A023AE00D40}" dt="2024-02-02T10:06:43.363" v="1066" actId="165"/>
          <ac:spMkLst>
            <pc:docMk/>
            <pc:sldMk cId="249257487" sldId="259"/>
            <ac:spMk id="85" creationId="{FF443B57-25A1-697B-6BB2-F23F8138750D}"/>
          </ac:spMkLst>
        </pc:spChg>
        <pc:spChg chg="mod">
          <ac:chgData name="Aiden Hendrickx" userId="b3e63f82dea26a3f" providerId="LiveId" clId="{C5D7819B-D6D1-4CF1-8377-6A023AE00D40}" dt="2024-02-02T10:06:43.363" v="1066" actId="165"/>
          <ac:spMkLst>
            <pc:docMk/>
            <pc:sldMk cId="249257487" sldId="259"/>
            <ac:spMk id="86" creationId="{DFAA076A-BB7B-48D5-0B36-1D3BD0447685}"/>
          </ac:spMkLst>
        </pc:spChg>
        <pc:spChg chg="mod">
          <ac:chgData name="Aiden Hendrickx" userId="b3e63f82dea26a3f" providerId="LiveId" clId="{C5D7819B-D6D1-4CF1-8377-6A023AE00D40}" dt="2024-02-02T10:06:43.363" v="1066" actId="165"/>
          <ac:spMkLst>
            <pc:docMk/>
            <pc:sldMk cId="249257487" sldId="259"/>
            <ac:spMk id="87" creationId="{7FCC0843-332C-AB1A-B395-F14D113FC6A5}"/>
          </ac:spMkLst>
        </pc:spChg>
        <pc:spChg chg="mod">
          <ac:chgData name="Aiden Hendrickx" userId="b3e63f82dea26a3f" providerId="LiveId" clId="{C5D7819B-D6D1-4CF1-8377-6A023AE00D40}" dt="2024-02-02T10:06:43.363" v="1066" actId="165"/>
          <ac:spMkLst>
            <pc:docMk/>
            <pc:sldMk cId="249257487" sldId="259"/>
            <ac:spMk id="88" creationId="{DD5B8B27-C1D1-35B2-C913-8D7BA8BFFE40}"/>
          </ac:spMkLst>
        </pc:spChg>
        <pc:spChg chg="mod">
          <ac:chgData name="Aiden Hendrickx" userId="b3e63f82dea26a3f" providerId="LiveId" clId="{C5D7819B-D6D1-4CF1-8377-6A023AE00D40}" dt="2024-02-02T10:06:43.363" v="1066" actId="165"/>
          <ac:spMkLst>
            <pc:docMk/>
            <pc:sldMk cId="249257487" sldId="259"/>
            <ac:spMk id="89" creationId="{3DB4AB7F-77D7-FE71-8B8F-956E704F9879}"/>
          </ac:spMkLst>
        </pc:spChg>
        <pc:spChg chg="mod">
          <ac:chgData name="Aiden Hendrickx" userId="b3e63f82dea26a3f" providerId="LiveId" clId="{C5D7819B-D6D1-4CF1-8377-6A023AE00D40}" dt="2024-02-02T10:06:43.363" v="1066" actId="165"/>
          <ac:spMkLst>
            <pc:docMk/>
            <pc:sldMk cId="249257487" sldId="259"/>
            <ac:spMk id="90" creationId="{60085EC9-9392-5685-5826-4523AF60B863}"/>
          </ac:spMkLst>
        </pc:spChg>
        <pc:spChg chg="mod">
          <ac:chgData name="Aiden Hendrickx" userId="b3e63f82dea26a3f" providerId="LiveId" clId="{C5D7819B-D6D1-4CF1-8377-6A023AE00D40}" dt="2024-02-02T10:06:43.363" v="1066" actId="165"/>
          <ac:spMkLst>
            <pc:docMk/>
            <pc:sldMk cId="249257487" sldId="259"/>
            <ac:spMk id="92" creationId="{72314F64-95C8-2F4F-E272-E5D58937AA4B}"/>
          </ac:spMkLst>
        </pc:spChg>
        <pc:spChg chg="mod">
          <ac:chgData name="Aiden Hendrickx" userId="b3e63f82dea26a3f" providerId="LiveId" clId="{C5D7819B-D6D1-4CF1-8377-6A023AE00D40}" dt="2024-02-02T10:06:43.363" v="1066" actId="165"/>
          <ac:spMkLst>
            <pc:docMk/>
            <pc:sldMk cId="249257487" sldId="259"/>
            <ac:spMk id="93" creationId="{855A8B40-4110-1115-A079-5FC3113248BA}"/>
          </ac:spMkLst>
        </pc:spChg>
        <pc:grpChg chg="add mod">
          <ac:chgData name="Aiden Hendrickx" userId="b3e63f82dea26a3f" providerId="LiveId" clId="{C5D7819B-D6D1-4CF1-8377-6A023AE00D40}" dt="2024-02-02T10:07:57.683" v="1181" actId="164"/>
          <ac:grpSpMkLst>
            <pc:docMk/>
            <pc:sldMk cId="249257487" sldId="259"/>
            <ac:grpSpMk id="5" creationId="{8C68F958-635D-4CD4-A0FC-D9613CD14158}"/>
          </ac:grpSpMkLst>
        </pc:grpChg>
        <pc:grpChg chg="add mod">
          <ac:chgData name="Aiden Hendrickx" userId="b3e63f82dea26a3f" providerId="LiveId" clId="{C5D7819B-D6D1-4CF1-8377-6A023AE00D40}" dt="2024-02-02T10:07:57.683" v="1181" actId="164"/>
          <ac:grpSpMkLst>
            <pc:docMk/>
            <pc:sldMk cId="249257487" sldId="259"/>
            <ac:grpSpMk id="6" creationId="{6076744D-2448-F7EC-3B14-CA0759EE4A54}"/>
          </ac:grpSpMkLst>
        </pc:grpChg>
        <pc:grpChg chg="mod">
          <ac:chgData name="Aiden Hendrickx" userId="b3e63f82dea26a3f" providerId="LiveId" clId="{C5D7819B-D6D1-4CF1-8377-6A023AE00D40}" dt="2024-02-02T10:06:48.868" v="1067"/>
          <ac:grpSpMkLst>
            <pc:docMk/>
            <pc:sldMk cId="249257487" sldId="259"/>
            <ac:grpSpMk id="8" creationId="{FACB6AD3-54A2-DAE6-206E-09591466E757}"/>
          </ac:grpSpMkLst>
        </pc:grpChg>
        <pc:grpChg chg="mod topLvl">
          <ac:chgData name="Aiden Hendrickx" userId="b3e63f82dea26a3f" providerId="LiveId" clId="{C5D7819B-D6D1-4CF1-8377-6A023AE00D40}" dt="2024-02-02T10:07:03.805" v="1071" actId="1076"/>
          <ac:grpSpMkLst>
            <pc:docMk/>
            <pc:sldMk cId="249257487" sldId="259"/>
            <ac:grpSpMk id="11" creationId="{E42A8C24-A947-9EE5-9494-DF6EE7356EB0}"/>
          </ac:grpSpMkLst>
        </pc:grpChg>
        <pc:grpChg chg="add mod">
          <ac:chgData name="Aiden Hendrickx" userId="b3e63f82dea26a3f" providerId="LiveId" clId="{C5D7819B-D6D1-4CF1-8377-6A023AE00D40}" dt="2024-02-02T10:11:41.144" v="1222" actId="1076"/>
          <ac:grpSpMkLst>
            <pc:docMk/>
            <pc:sldMk cId="249257487" sldId="259"/>
            <ac:grpSpMk id="21" creationId="{7980C5C9-A72F-DE1B-1A9B-D8E17AB3B8A9}"/>
          </ac:grpSpMkLst>
        </pc:grpChg>
        <pc:grpChg chg="mod topLvl">
          <ac:chgData name="Aiden Hendrickx" userId="b3e63f82dea26a3f" providerId="LiveId" clId="{C5D7819B-D6D1-4CF1-8377-6A023AE00D40}" dt="2024-02-02T10:06:43.363" v="1066" actId="165"/>
          <ac:grpSpMkLst>
            <pc:docMk/>
            <pc:sldMk cId="249257487" sldId="259"/>
            <ac:grpSpMk id="83" creationId="{09A88BAF-3C1C-CF9F-DEC2-5EF69C17101B}"/>
          </ac:grpSpMkLst>
        </pc:grpChg>
        <pc:grpChg chg="mod">
          <ac:chgData name="Aiden Hendrickx" userId="b3e63f82dea26a3f" providerId="LiveId" clId="{C5D7819B-D6D1-4CF1-8377-6A023AE00D40}" dt="2024-02-02T10:06:43.363" v="1066" actId="165"/>
          <ac:grpSpMkLst>
            <pc:docMk/>
            <pc:sldMk cId="249257487" sldId="259"/>
            <ac:grpSpMk id="84" creationId="{C71136F3-F6E3-FBAC-77F8-49E37156CB88}"/>
          </ac:grpSpMkLst>
        </pc:grpChg>
        <pc:grpChg chg="add del mod">
          <ac:chgData name="Aiden Hendrickx" userId="b3e63f82dea26a3f" providerId="LiveId" clId="{C5D7819B-D6D1-4CF1-8377-6A023AE00D40}" dt="2024-02-02T10:06:43.363" v="1066" actId="165"/>
          <ac:grpSpMkLst>
            <pc:docMk/>
            <pc:sldMk cId="249257487" sldId="259"/>
            <ac:grpSpMk id="95" creationId="{382AE4A9-AF2E-DD6C-A448-11F10E7EC6A6}"/>
          </ac:grpSpMkLst>
        </pc:grpChg>
        <pc:picChg chg="mod">
          <ac:chgData name="Aiden Hendrickx" userId="b3e63f82dea26a3f" providerId="LiveId" clId="{C5D7819B-D6D1-4CF1-8377-6A023AE00D40}" dt="2024-02-02T10:06:19.614" v="1063"/>
          <ac:picMkLst>
            <pc:docMk/>
            <pc:sldMk cId="249257487" sldId="259"/>
            <ac:picMk id="7" creationId="{F90E480B-A126-5DED-58CC-6476F989A488}"/>
          </ac:picMkLst>
        </pc:picChg>
        <pc:picChg chg="mod">
          <ac:chgData name="Aiden Hendrickx" userId="b3e63f82dea26a3f" providerId="LiveId" clId="{C5D7819B-D6D1-4CF1-8377-6A023AE00D40}" dt="2024-02-02T10:06:43.363" v="1066" actId="165"/>
          <ac:picMkLst>
            <pc:docMk/>
            <pc:sldMk cId="249257487" sldId="259"/>
            <ac:picMk id="9" creationId="{CDA26D41-123D-A89E-40D5-225100C392D4}"/>
          </ac:picMkLst>
        </pc:picChg>
        <pc:cxnChg chg="mod">
          <ac:chgData name="Aiden Hendrickx" userId="b3e63f82dea26a3f" providerId="LiveId" clId="{C5D7819B-D6D1-4CF1-8377-6A023AE00D40}" dt="2024-02-02T10:06:48.868" v="1067"/>
          <ac:cxnSpMkLst>
            <pc:docMk/>
            <pc:sldMk cId="249257487" sldId="259"/>
            <ac:cxnSpMk id="18" creationId="{B7313282-85A3-3ECF-8274-72054C99AC55}"/>
          </ac:cxnSpMkLst>
        </pc:cxnChg>
        <pc:cxnChg chg="mod">
          <ac:chgData name="Aiden Hendrickx" userId="b3e63f82dea26a3f" providerId="LiveId" clId="{C5D7819B-D6D1-4CF1-8377-6A023AE00D40}" dt="2024-02-02T10:06:43.363" v="1066" actId="165"/>
          <ac:cxnSpMkLst>
            <pc:docMk/>
            <pc:sldMk cId="249257487" sldId="259"/>
            <ac:cxnSpMk id="91" creationId="{4A9A6009-3FB1-AD45-1EE7-066296436B40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7082" y="1355149"/>
            <a:ext cx="5293599" cy="2882806"/>
          </a:xfrm>
        </p:spPr>
        <p:txBody>
          <a:bodyPr anchor="b"/>
          <a:lstStyle>
            <a:lvl1pPr algn="ctr">
              <a:defRPr sz="4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8471" y="4349128"/>
            <a:ext cx="4670822" cy="1999179"/>
          </a:xfrm>
        </p:spPr>
        <p:txBody>
          <a:bodyPr/>
          <a:lstStyle>
            <a:lvl1pPr marL="0" indent="0" algn="ctr">
              <a:buNone/>
              <a:defRPr sz="1635"/>
            </a:lvl1pPr>
            <a:lvl2pPr marL="311399" indent="0" algn="ctr">
              <a:buNone/>
              <a:defRPr sz="1362"/>
            </a:lvl2pPr>
            <a:lvl3pPr marL="622798" indent="0" algn="ctr">
              <a:buNone/>
              <a:defRPr sz="1226"/>
            </a:lvl3pPr>
            <a:lvl4pPr marL="934197" indent="0" algn="ctr">
              <a:buNone/>
              <a:defRPr sz="1090"/>
            </a:lvl4pPr>
            <a:lvl5pPr marL="1245596" indent="0" algn="ctr">
              <a:buNone/>
              <a:defRPr sz="1090"/>
            </a:lvl5pPr>
            <a:lvl6pPr marL="1556995" indent="0" algn="ctr">
              <a:buNone/>
              <a:defRPr sz="1090"/>
            </a:lvl6pPr>
            <a:lvl7pPr marL="1868394" indent="0" algn="ctr">
              <a:buNone/>
              <a:defRPr sz="1090"/>
            </a:lvl7pPr>
            <a:lvl8pPr marL="2179792" indent="0" algn="ctr">
              <a:buNone/>
              <a:defRPr sz="1090"/>
            </a:lvl8pPr>
            <a:lvl9pPr marL="2491191" indent="0" algn="ctr">
              <a:buNone/>
              <a:defRPr sz="109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454326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206026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56743" y="440855"/>
            <a:ext cx="1342861" cy="70172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8159" y="440855"/>
            <a:ext cx="3950737" cy="70172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558259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669455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915" y="2064352"/>
            <a:ext cx="5371446" cy="3444416"/>
          </a:xfrm>
        </p:spPr>
        <p:txBody>
          <a:bodyPr anchor="b"/>
          <a:lstStyle>
            <a:lvl1pPr>
              <a:defRPr sz="40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915" y="5541353"/>
            <a:ext cx="5371446" cy="1811337"/>
          </a:xfrm>
        </p:spPr>
        <p:txBody>
          <a:bodyPr/>
          <a:lstStyle>
            <a:lvl1pPr marL="0" indent="0">
              <a:buNone/>
              <a:defRPr sz="1635">
                <a:solidFill>
                  <a:schemeClr val="tx1">
                    <a:tint val="82000"/>
                  </a:schemeClr>
                </a:solidFill>
              </a:defRPr>
            </a:lvl1pPr>
            <a:lvl2pPr marL="311399" indent="0">
              <a:buNone/>
              <a:defRPr sz="1362">
                <a:solidFill>
                  <a:schemeClr val="tx1">
                    <a:tint val="82000"/>
                  </a:schemeClr>
                </a:solidFill>
              </a:defRPr>
            </a:lvl2pPr>
            <a:lvl3pPr marL="622798" indent="0">
              <a:buNone/>
              <a:defRPr sz="1226">
                <a:solidFill>
                  <a:schemeClr val="tx1">
                    <a:tint val="82000"/>
                  </a:schemeClr>
                </a:solidFill>
              </a:defRPr>
            </a:lvl3pPr>
            <a:lvl4pPr marL="934197" indent="0">
              <a:buNone/>
              <a:defRPr sz="1090">
                <a:solidFill>
                  <a:schemeClr val="tx1">
                    <a:tint val="82000"/>
                  </a:schemeClr>
                </a:solidFill>
              </a:defRPr>
            </a:lvl4pPr>
            <a:lvl5pPr marL="1245596" indent="0">
              <a:buNone/>
              <a:defRPr sz="1090">
                <a:solidFill>
                  <a:schemeClr val="tx1">
                    <a:tint val="82000"/>
                  </a:schemeClr>
                </a:solidFill>
              </a:defRPr>
            </a:lvl5pPr>
            <a:lvl6pPr marL="1556995" indent="0">
              <a:buNone/>
              <a:defRPr sz="1090">
                <a:solidFill>
                  <a:schemeClr val="tx1">
                    <a:tint val="82000"/>
                  </a:schemeClr>
                </a:solidFill>
              </a:defRPr>
            </a:lvl6pPr>
            <a:lvl7pPr marL="1868394" indent="0">
              <a:buNone/>
              <a:defRPr sz="1090">
                <a:solidFill>
                  <a:schemeClr val="tx1">
                    <a:tint val="82000"/>
                  </a:schemeClr>
                </a:solidFill>
              </a:defRPr>
            </a:lvl7pPr>
            <a:lvl8pPr marL="2179792" indent="0">
              <a:buNone/>
              <a:defRPr sz="1090">
                <a:solidFill>
                  <a:schemeClr val="tx1">
                    <a:tint val="82000"/>
                  </a:schemeClr>
                </a:solidFill>
              </a:defRPr>
            </a:lvl8pPr>
            <a:lvl9pPr marL="2491191" indent="0">
              <a:buNone/>
              <a:defRPr sz="109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121790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8159" y="2204273"/>
            <a:ext cx="2646799" cy="525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52805" y="2204273"/>
            <a:ext cx="2646799" cy="525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381863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440856"/>
            <a:ext cx="5371446" cy="160049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971" y="2029849"/>
            <a:ext cx="2634635" cy="994797"/>
          </a:xfrm>
        </p:spPr>
        <p:txBody>
          <a:bodyPr anchor="b"/>
          <a:lstStyle>
            <a:lvl1pPr marL="0" indent="0">
              <a:buNone/>
              <a:defRPr sz="1635" b="1"/>
            </a:lvl1pPr>
            <a:lvl2pPr marL="311399" indent="0">
              <a:buNone/>
              <a:defRPr sz="1362" b="1"/>
            </a:lvl2pPr>
            <a:lvl3pPr marL="622798" indent="0">
              <a:buNone/>
              <a:defRPr sz="1226" b="1"/>
            </a:lvl3pPr>
            <a:lvl4pPr marL="934197" indent="0">
              <a:buNone/>
              <a:defRPr sz="1090" b="1"/>
            </a:lvl4pPr>
            <a:lvl5pPr marL="1245596" indent="0">
              <a:buNone/>
              <a:defRPr sz="1090" b="1"/>
            </a:lvl5pPr>
            <a:lvl6pPr marL="1556995" indent="0">
              <a:buNone/>
              <a:defRPr sz="1090" b="1"/>
            </a:lvl6pPr>
            <a:lvl7pPr marL="1868394" indent="0">
              <a:buNone/>
              <a:defRPr sz="1090" b="1"/>
            </a:lvl7pPr>
            <a:lvl8pPr marL="2179792" indent="0">
              <a:buNone/>
              <a:defRPr sz="1090" b="1"/>
            </a:lvl8pPr>
            <a:lvl9pPr marL="2491191" indent="0">
              <a:buNone/>
              <a:defRPr sz="109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971" y="3024646"/>
            <a:ext cx="2634635" cy="44487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52806" y="2029849"/>
            <a:ext cx="2647610" cy="994797"/>
          </a:xfrm>
        </p:spPr>
        <p:txBody>
          <a:bodyPr anchor="b"/>
          <a:lstStyle>
            <a:lvl1pPr marL="0" indent="0">
              <a:buNone/>
              <a:defRPr sz="1635" b="1"/>
            </a:lvl1pPr>
            <a:lvl2pPr marL="311399" indent="0">
              <a:buNone/>
              <a:defRPr sz="1362" b="1"/>
            </a:lvl2pPr>
            <a:lvl3pPr marL="622798" indent="0">
              <a:buNone/>
              <a:defRPr sz="1226" b="1"/>
            </a:lvl3pPr>
            <a:lvl4pPr marL="934197" indent="0">
              <a:buNone/>
              <a:defRPr sz="1090" b="1"/>
            </a:lvl4pPr>
            <a:lvl5pPr marL="1245596" indent="0">
              <a:buNone/>
              <a:defRPr sz="1090" b="1"/>
            </a:lvl5pPr>
            <a:lvl6pPr marL="1556995" indent="0">
              <a:buNone/>
              <a:defRPr sz="1090" b="1"/>
            </a:lvl6pPr>
            <a:lvl7pPr marL="1868394" indent="0">
              <a:buNone/>
              <a:defRPr sz="1090" b="1"/>
            </a:lvl7pPr>
            <a:lvl8pPr marL="2179792" indent="0">
              <a:buNone/>
              <a:defRPr sz="1090" b="1"/>
            </a:lvl8pPr>
            <a:lvl9pPr marL="2491191" indent="0">
              <a:buNone/>
              <a:defRPr sz="109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52806" y="3024646"/>
            <a:ext cx="2647610" cy="444879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711335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745774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372822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552027"/>
            <a:ext cx="2008616" cy="1932093"/>
          </a:xfrm>
        </p:spPr>
        <p:txBody>
          <a:bodyPr anchor="b"/>
          <a:lstStyle>
            <a:lvl1pPr>
              <a:defRPr sz="21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7610" y="1192226"/>
            <a:ext cx="3152805" cy="5884451"/>
          </a:xfrm>
        </p:spPr>
        <p:txBody>
          <a:bodyPr/>
          <a:lstStyle>
            <a:lvl1pPr>
              <a:defRPr sz="2180"/>
            </a:lvl1pPr>
            <a:lvl2pPr>
              <a:defRPr sz="1907"/>
            </a:lvl2pPr>
            <a:lvl3pPr>
              <a:defRPr sz="1635"/>
            </a:lvl3pPr>
            <a:lvl4pPr>
              <a:defRPr sz="1362"/>
            </a:lvl4pPr>
            <a:lvl5pPr>
              <a:defRPr sz="1362"/>
            </a:lvl5pPr>
            <a:lvl6pPr>
              <a:defRPr sz="1362"/>
            </a:lvl6pPr>
            <a:lvl7pPr>
              <a:defRPr sz="1362"/>
            </a:lvl7pPr>
            <a:lvl8pPr>
              <a:defRPr sz="1362"/>
            </a:lvl8pPr>
            <a:lvl9pPr>
              <a:defRPr sz="136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484120"/>
            <a:ext cx="2008616" cy="4602140"/>
          </a:xfrm>
        </p:spPr>
        <p:txBody>
          <a:bodyPr/>
          <a:lstStyle>
            <a:lvl1pPr marL="0" indent="0">
              <a:buNone/>
              <a:defRPr sz="1090"/>
            </a:lvl1pPr>
            <a:lvl2pPr marL="311399" indent="0">
              <a:buNone/>
              <a:defRPr sz="954"/>
            </a:lvl2pPr>
            <a:lvl3pPr marL="622798" indent="0">
              <a:buNone/>
              <a:defRPr sz="817"/>
            </a:lvl3pPr>
            <a:lvl4pPr marL="934197" indent="0">
              <a:buNone/>
              <a:defRPr sz="681"/>
            </a:lvl4pPr>
            <a:lvl5pPr marL="1245596" indent="0">
              <a:buNone/>
              <a:defRPr sz="681"/>
            </a:lvl5pPr>
            <a:lvl6pPr marL="1556995" indent="0">
              <a:buNone/>
              <a:defRPr sz="681"/>
            </a:lvl6pPr>
            <a:lvl7pPr marL="1868394" indent="0">
              <a:buNone/>
              <a:defRPr sz="681"/>
            </a:lvl7pPr>
            <a:lvl8pPr marL="2179792" indent="0">
              <a:buNone/>
              <a:defRPr sz="681"/>
            </a:lvl8pPr>
            <a:lvl9pPr marL="2491191" indent="0">
              <a:buNone/>
              <a:defRPr sz="68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023654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552027"/>
            <a:ext cx="2008616" cy="1932093"/>
          </a:xfrm>
        </p:spPr>
        <p:txBody>
          <a:bodyPr anchor="b"/>
          <a:lstStyle>
            <a:lvl1pPr>
              <a:defRPr sz="21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7610" y="1192226"/>
            <a:ext cx="3152805" cy="5884451"/>
          </a:xfrm>
        </p:spPr>
        <p:txBody>
          <a:bodyPr anchor="t"/>
          <a:lstStyle>
            <a:lvl1pPr marL="0" indent="0">
              <a:buNone/>
              <a:defRPr sz="2180"/>
            </a:lvl1pPr>
            <a:lvl2pPr marL="311399" indent="0">
              <a:buNone/>
              <a:defRPr sz="1907"/>
            </a:lvl2pPr>
            <a:lvl3pPr marL="622798" indent="0">
              <a:buNone/>
              <a:defRPr sz="1635"/>
            </a:lvl3pPr>
            <a:lvl4pPr marL="934197" indent="0">
              <a:buNone/>
              <a:defRPr sz="1362"/>
            </a:lvl4pPr>
            <a:lvl5pPr marL="1245596" indent="0">
              <a:buNone/>
              <a:defRPr sz="1362"/>
            </a:lvl5pPr>
            <a:lvl6pPr marL="1556995" indent="0">
              <a:buNone/>
              <a:defRPr sz="1362"/>
            </a:lvl6pPr>
            <a:lvl7pPr marL="1868394" indent="0">
              <a:buNone/>
              <a:defRPr sz="1362"/>
            </a:lvl7pPr>
            <a:lvl8pPr marL="2179792" indent="0">
              <a:buNone/>
              <a:defRPr sz="1362"/>
            </a:lvl8pPr>
            <a:lvl9pPr marL="2491191" indent="0">
              <a:buNone/>
              <a:defRPr sz="1362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484120"/>
            <a:ext cx="2008616" cy="4602140"/>
          </a:xfrm>
        </p:spPr>
        <p:txBody>
          <a:bodyPr/>
          <a:lstStyle>
            <a:lvl1pPr marL="0" indent="0">
              <a:buNone/>
              <a:defRPr sz="1090"/>
            </a:lvl1pPr>
            <a:lvl2pPr marL="311399" indent="0">
              <a:buNone/>
              <a:defRPr sz="954"/>
            </a:lvl2pPr>
            <a:lvl3pPr marL="622798" indent="0">
              <a:buNone/>
              <a:defRPr sz="817"/>
            </a:lvl3pPr>
            <a:lvl4pPr marL="934197" indent="0">
              <a:buNone/>
              <a:defRPr sz="681"/>
            </a:lvl4pPr>
            <a:lvl5pPr marL="1245596" indent="0">
              <a:buNone/>
              <a:defRPr sz="681"/>
            </a:lvl5pPr>
            <a:lvl6pPr marL="1556995" indent="0">
              <a:buNone/>
              <a:defRPr sz="681"/>
            </a:lvl6pPr>
            <a:lvl7pPr marL="1868394" indent="0">
              <a:buNone/>
              <a:defRPr sz="681"/>
            </a:lvl7pPr>
            <a:lvl8pPr marL="2179792" indent="0">
              <a:buNone/>
              <a:defRPr sz="681"/>
            </a:lvl8pPr>
            <a:lvl9pPr marL="2491191" indent="0">
              <a:buNone/>
              <a:defRPr sz="68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523547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8159" y="440856"/>
            <a:ext cx="5371446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159" y="2204273"/>
            <a:ext cx="5371446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8159" y="7674706"/>
            <a:ext cx="140124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7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3DA94A-5B58-4FA8-9760-8D02D7FFFEBB}" type="datetimeFigureOut">
              <a:rPr lang="en-BE" smtClean="0"/>
              <a:t>13/02/2024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62947" y="7674706"/>
            <a:ext cx="210187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7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8357" y="7674706"/>
            <a:ext cx="140124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7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105ECC-362B-4029-9B20-3C3B9154D29C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484277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22798" rtl="0" eaLnBrk="1" latinLnBrk="0" hangingPunct="1">
        <a:lnSpc>
          <a:spcPct val="90000"/>
        </a:lnSpc>
        <a:spcBef>
          <a:spcPct val="0"/>
        </a:spcBef>
        <a:buNone/>
        <a:defRPr sz="29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699" indent="-155699" algn="l" defTabSz="622798" rtl="0" eaLnBrk="1" latinLnBrk="0" hangingPunct="1">
        <a:lnSpc>
          <a:spcPct val="90000"/>
        </a:lnSpc>
        <a:spcBef>
          <a:spcPts val="681"/>
        </a:spcBef>
        <a:buFont typeface="Arial" panose="020B0604020202020204" pitchFamily="34" charset="0"/>
        <a:buChar char="•"/>
        <a:defRPr sz="1907" kern="1200">
          <a:solidFill>
            <a:schemeClr val="tx1"/>
          </a:solidFill>
          <a:latin typeface="+mn-lt"/>
          <a:ea typeface="+mn-ea"/>
          <a:cs typeface="+mn-cs"/>
        </a:defRPr>
      </a:lvl1pPr>
      <a:lvl2pPr marL="467098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635" kern="1200">
          <a:solidFill>
            <a:schemeClr val="tx1"/>
          </a:solidFill>
          <a:latin typeface="+mn-lt"/>
          <a:ea typeface="+mn-ea"/>
          <a:cs typeface="+mn-cs"/>
        </a:defRPr>
      </a:lvl2pPr>
      <a:lvl3pPr marL="778497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362" kern="1200">
          <a:solidFill>
            <a:schemeClr val="tx1"/>
          </a:solidFill>
          <a:latin typeface="+mn-lt"/>
          <a:ea typeface="+mn-ea"/>
          <a:cs typeface="+mn-cs"/>
        </a:defRPr>
      </a:lvl3pPr>
      <a:lvl4pPr marL="1089896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4pPr>
      <a:lvl5pPr marL="1401295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5pPr>
      <a:lvl6pPr marL="1712694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6pPr>
      <a:lvl7pPr marL="2024093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7pPr>
      <a:lvl8pPr marL="2335492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8pPr>
      <a:lvl9pPr marL="2646891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sz="12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1pPr>
      <a:lvl2pPr marL="311399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2pPr>
      <a:lvl3pPr marL="622798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3pPr>
      <a:lvl4pPr marL="934197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4pPr>
      <a:lvl5pPr marL="1245596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5pPr>
      <a:lvl6pPr marL="1556995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6pPr>
      <a:lvl7pPr marL="1868394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7pPr>
      <a:lvl8pPr marL="2179792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8pPr>
      <a:lvl9pPr marL="2491191" algn="l" defTabSz="622798" rtl="0" eaLnBrk="1" latinLnBrk="0" hangingPunct="1">
        <a:defRPr sz="12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E660A33F-0FB1-193E-A88C-2ABCDA33EC9D}"/>
              </a:ext>
            </a:extLst>
          </p:cNvPr>
          <p:cNvGrpSpPr/>
          <p:nvPr/>
        </p:nvGrpSpPr>
        <p:grpSpPr>
          <a:xfrm>
            <a:off x="0" y="0"/>
            <a:ext cx="6227763" cy="6748871"/>
            <a:chOff x="0" y="0"/>
            <a:chExt cx="6227763" cy="6748871"/>
          </a:xfrm>
        </p:grpSpPr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48860674-2B26-4BB3-D127-CEF65154D78B}"/>
                </a:ext>
              </a:extLst>
            </p:cNvPr>
            <p:cNvGrpSpPr/>
            <p:nvPr/>
          </p:nvGrpSpPr>
          <p:grpSpPr>
            <a:xfrm>
              <a:off x="233881" y="963318"/>
              <a:ext cx="5760000" cy="2822419"/>
              <a:chOff x="233881" y="26058"/>
              <a:chExt cx="5760000" cy="2822419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A6ADA81D-D6D4-E69D-B97D-67922FFCF3ED}"/>
                  </a:ext>
                </a:extLst>
              </p:cNvPr>
              <p:cNvGrpSpPr/>
              <p:nvPr/>
            </p:nvGrpSpPr>
            <p:grpSpPr>
              <a:xfrm>
                <a:off x="233881" y="165100"/>
                <a:ext cx="5760000" cy="2683377"/>
                <a:chOff x="233881" y="0"/>
                <a:chExt cx="5760000" cy="2683377"/>
              </a:xfrm>
            </p:grpSpPr>
            <p:pic>
              <p:nvPicPr>
                <p:cNvPr id="5" name="Picture 4" descr="A graph with many black and white text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D88A6E01-C2C5-3677-3006-F6F1019631C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710"/>
                <a:stretch/>
              </p:blipFill>
              <p:spPr>
                <a:xfrm>
                  <a:off x="233881" y="0"/>
                  <a:ext cx="5760000" cy="2683377"/>
                </a:xfrm>
                <a:prstGeom prst="rect">
                  <a:avLst/>
                </a:prstGeom>
              </p:spPr>
            </p:pic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6E1B0303-C9E8-9B6B-493C-61F9C035D847}"/>
                    </a:ext>
                  </a:extLst>
                </p:cNvPr>
                <p:cNvSpPr txBox="1"/>
                <p:nvPr/>
              </p:nvSpPr>
              <p:spPr>
                <a:xfrm>
                  <a:off x="670560" y="251460"/>
                  <a:ext cx="51816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i="1" dirty="0"/>
                    <a:t>R</a:t>
                  </a:r>
                  <a:r>
                    <a:rPr lang="en-BE" sz="800" i="1" baseline="30000" dirty="0"/>
                    <a:t>2</a:t>
                  </a:r>
                  <a:r>
                    <a:rPr lang="en-BE" sz="800" i="1" baseline="-25000" dirty="0"/>
                    <a:t>adj</a:t>
                  </a:r>
                  <a:r>
                    <a:rPr lang="en-BE" sz="800" i="1" dirty="0"/>
                    <a:t> = 0.60</a:t>
                  </a:r>
                </a:p>
                <a:p>
                  <a:r>
                    <a:rPr lang="en-BE" sz="800" i="1" dirty="0"/>
                    <a:t>p &lt; 2.2e-16</a:t>
                  </a:r>
                </a:p>
              </p:txBody>
            </p:sp>
          </p:grpSp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CFAB2576-79F2-AB07-337D-DD80BB039997}"/>
                  </a:ext>
                </a:extLst>
              </p:cNvPr>
              <p:cNvGrpSpPr/>
              <p:nvPr/>
            </p:nvGrpSpPr>
            <p:grpSpPr>
              <a:xfrm>
                <a:off x="651722" y="26058"/>
                <a:ext cx="5295789" cy="315638"/>
                <a:chOff x="651722" y="-111102"/>
                <a:chExt cx="5295789" cy="315638"/>
              </a:xfrm>
            </p:grpSpPr>
            <p:grpSp>
              <p:nvGrpSpPr>
                <p:cNvPr id="29" name="Group 28">
                  <a:extLst>
                    <a:ext uri="{FF2B5EF4-FFF2-40B4-BE49-F238E27FC236}">
                      <a16:creationId xmlns:a16="http://schemas.microsoft.com/office/drawing/2014/main" id="{88A25EEE-C67B-6F10-CF95-DB102FC409E7}"/>
                    </a:ext>
                  </a:extLst>
                </p:cNvPr>
                <p:cNvGrpSpPr/>
                <p:nvPr/>
              </p:nvGrpSpPr>
              <p:grpSpPr>
                <a:xfrm>
                  <a:off x="651722" y="34651"/>
                  <a:ext cx="5295789" cy="169885"/>
                  <a:chOff x="649958" y="1488905"/>
                  <a:chExt cx="5295789" cy="169885"/>
                </a:xfrm>
              </p:grpSpPr>
              <p:sp>
                <p:nvSpPr>
                  <p:cNvPr id="21" name="pl259">
                    <a:extLst>
                      <a:ext uri="{FF2B5EF4-FFF2-40B4-BE49-F238E27FC236}">
                        <a16:creationId xmlns:a16="http://schemas.microsoft.com/office/drawing/2014/main" id="{27E23BDF-E4F2-8BFC-21A3-D07E3F48E163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785023" y="1511391"/>
                    <a:ext cx="0" cy="270130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347229">
                        <a:moveTo>
                          <a:pt x="0" y="347229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A020F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22" name="pl257">
                    <a:extLst>
                      <a:ext uri="{FF2B5EF4-FFF2-40B4-BE49-F238E27FC236}">
                        <a16:creationId xmlns:a16="http://schemas.microsoft.com/office/drawing/2014/main" id="{638F7C47-494E-2C31-3C18-898A3009FD90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456983" y="-999857"/>
                    <a:ext cx="0" cy="4977524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9375187">
                        <a:moveTo>
                          <a:pt x="0" y="9375187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CC9900"/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 dirty="0"/>
                  </a:p>
                </p:txBody>
              </p:sp>
              <p:cxnSp>
                <p:nvCxnSpPr>
                  <p:cNvPr id="23" name="Straight Connector 22">
                    <a:extLst>
                      <a:ext uri="{FF2B5EF4-FFF2-40B4-BE49-F238E27FC236}">
                        <a16:creationId xmlns:a16="http://schemas.microsoft.com/office/drawing/2014/main" id="{D02EC14C-3F4A-F64F-B3C9-02A5389ABFF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968221" y="1509023"/>
                    <a:ext cx="1" cy="149767"/>
                  </a:xfrm>
                  <a:prstGeom prst="line">
                    <a:avLst/>
                  </a:prstGeom>
                  <a:ln w="9525" cap="flat" cmpd="sng" algn="ctr">
                    <a:solidFill>
                      <a:srgbClr val="CC9900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" name="pl253">
                    <a:extLst>
                      <a:ext uri="{FF2B5EF4-FFF2-40B4-BE49-F238E27FC236}">
                        <a16:creationId xmlns:a16="http://schemas.microsoft.com/office/drawing/2014/main" id="{228D41F5-7827-E5DC-734D-09DD244BA124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4302803" y="3513"/>
                    <a:ext cx="0" cy="3285888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6076510">
                        <a:moveTo>
                          <a:pt x="0" y="6076510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00FFFF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28" name="pl255">
                    <a:extLst>
                      <a:ext uri="{FF2B5EF4-FFF2-40B4-BE49-F238E27FC236}">
                        <a16:creationId xmlns:a16="http://schemas.microsoft.com/office/drawing/2014/main" id="{AEA7A2F6-DA6C-BD6D-A20D-4ACCAF056EC5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1836188" y="822787"/>
                    <a:ext cx="0" cy="1647341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2951448">
                        <a:moveTo>
                          <a:pt x="0" y="2951448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FF000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</p:grp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73735F3E-CBE1-47A9-ED31-728AD82DDA97}"/>
                    </a:ext>
                  </a:extLst>
                </p:cNvPr>
                <p:cNvSpPr txBox="1"/>
                <p:nvPr/>
              </p:nvSpPr>
              <p:spPr>
                <a:xfrm>
                  <a:off x="738188" y="54769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XC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04FFFDD8-911A-DFF1-23FA-7030C31C0EA0}"/>
                    </a:ext>
                  </a:extLst>
                </p:cNvPr>
                <p:cNvSpPr txBox="1"/>
                <p:nvPr/>
              </p:nvSpPr>
              <p:spPr>
                <a:xfrm>
                  <a:off x="3391596" y="-111102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EC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C7F0AEAD-961C-E548-0EA2-15578BF3A30E}"/>
                    </a:ext>
                  </a:extLst>
                </p:cNvPr>
                <p:cNvSpPr txBox="1"/>
                <p:nvPr/>
              </p:nvSpPr>
              <p:spPr>
                <a:xfrm>
                  <a:off x="1745433" y="56732"/>
                  <a:ext cx="18503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AFR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18B7A273-07BA-C243-4BD2-DA6BD6B05473}"/>
                    </a:ext>
                  </a:extLst>
                </p:cNvPr>
                <p:cNvSpPr txBox="1"/>
                <p:nvPr/>
              </p:nvSpPr>
              <p:spPr>
                <a:xfrm>
                  <a:off x="4183473" y="56732"/>
                  <a:ext cx="24218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WIOI</a:t>
                  </a:r>
                </a:p>
              </p:txBody>
            </p:sp>
          </p:grpSp>
        </p:grpSp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277EBA44-819E-00A4-C947-D5FEC3762709}"/>
                </a:ext>
              </a:extLst>
            </p:cNvPr>
            <p:cNvGrpSpPr/>
            <p:nvPr/>
          </p:nvGrpSpPr>
          <p:grpSpPr>
            <a:xfrm>
              <a:off x="233881" y="3915688"/>
              <a:ext cx="5760000" cy="2833183"/>
              <a:chOff x="233881" y="2780308"/>
              <a:chExt cx="5760000" cy="2833183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3522054F-2434-B5CE-0CF2-571BE0C3B313}"/>
                  </a:ext>
                </a:extLst>
              </p:cNvPr>
              <p:cNvGrpSpPr/>
              <p:nvPr/>
            </p:nvGrpSpPr>
            <p:grpSpPr>
              <a:xfrm>
                <a:off x="233881" y="2887928"/>
                <a:ext cx="5760000" cy="2725563"/>
                <a:chOff x="233881" y="2683377"/>
                <a:chExt cx="5760000" cy="2725563"/>
              </a:xfrm>
            </p:grpSpPr>
            <p:pic>
              <p:nvPicPr>
                <p:cNvPr id="7" name="Picture 6" descr="A graph with many black and white text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7AF7EAEA-F78D-48A0-6B3F-FBE2C9FF3E6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alphaModFix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147"/>
                <a:stretch/>
              </p:blipFill>
              <p:spPr>
                <a:xfrm>
                  <a:off x="233881" y="2683377"/>
                  <a:ext cx="5760000" cy="2725563"/>
                </a:xfrm>
                <a:prstGeom prst="rect">
                  <a:avLst/>
                </a:prstGeom>
              </p:spPr>
            </p:pic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17ED35B2-7D1D-AF66-560E-18F4AD15095D}"/>
                    </a:ext>
                  </a:extLst>
                </p:cNvPr>
                <p:cNvSpPr txBox="1"/>
                <p:nvPr/>
              </p:nvSpPr>
              <p:spPr>
                <a:xfrm>
                  <a:off x="613410" y="2957973"/>
                  <a:ext cx="51816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i="1" dirty="0"/>
                    <a:t>R</a:t>
                  </a:r>
                  <a:r>
                    <a:rPr lang="en-BE" sz="800" i="1" baseline="30000" dirty="0"/>
                    <a:t>2</a:t>
                  </a:r>
                  <a:r>
                    <a:rPr lang="en-BE" sz="800" i="1" baseline="-25000" dirty="0"/>
                    <a:t>adj</a:t>
                  </a:r>
                  <a:r>
                    <a:rPr lang="en-BE" sz="800" i="1" dirty="0"/>
                    <a:t> = 0.70</a:t>
                  </a:r>
                </a:p>
                <a:p>
                  <a:r>
                    <a:rPr lang="en-BE" sz="800" i="1" dirty="0"/>
                    <a:t>p &lt; 2.2e-16</a:t>
                  </a:r>
                </a:p>
              </p:txBody>
            </p:sp>
          </p:grpSp>
          <p:grpSp>
            <p:nvGrpSpPr>
              <p:cNvPr id="71" name="Group 70">
                <a:extLst>
                  <a:ext uri="{FF2B5EF4-FFF2-40B4-BE49-F238E27FC236}">
                    <a16:creationId xmlns:a16="http://schemas.microsoft.com/office/drawing/2014/main" id="{99A2B627-7853-8909-647C-54DBA6DFD7E5}"/>
                  </a:ext>
                </a:extLst>
              </p:cNvPr>
              <p:cNvGrpSpPr/>
              <p:nvPr/>
            </p:nvGrpSpPr>
            <p:grpSpPr>
              <a:xfrm>
                <a:off x="581830" y="2780308"/>
                <a:ext cx="5365679" cy="315638"/>
                <a:chOff x="651722" y="-111102"/>
                <a:chExt cx="5295789" cy="315638"/>
              </a:xfrm>
            </p:grpSpPr>
            <p:grpSp>
              <p:nvGrpSpPr>
                <p:cNvPr id="72" name="Group 71">
                  <a:extLst>
                    <a:ext uri="{FF2B5EF4-FFF2-40B4-BE49-F238E27FC236}">
                      <a16:creationId xmlns:a16="http://schemas.microsoft.com/office/drawing/2014/main" id="{1B0721FF-B747-7DEE-EB38-09C449F982BC}"/>
                    </a:ext>
                  </a:extLst>
                </p:cNvPr>
                <p:cNvGrpSpPr/>
                <p:nvPr/>
              </p:nvGrpSpPr>
              <p:grpSpPr>
                <a:xfrm>
                  <a:off x="651722" y="34651"/>
                  <a:ext cx="5295789" cy="169885"/>
                  <a:chOff x="649958" y="1488905"/>
                  <a:chExt cx="5295789" cy="169885"/>
                </a:xfrm>
              </p:grpSpPr>
              <p:sp>
                <p:nvSpPr>
                  <p:cNvPr id="77" name="pl259">
                    <a:extLst>
                      <a:ext uri="{FF2B5EF4-FFF2-40B4-BE49-F238E27FC236}">
                        <a16:creationId xmlns:a16="http://schemas.microsoft.com/office/drawing/2014/main" id="{164486BF-5CB2-6AC8-EC10-F4EBCE27AEE8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785023" y="1511391"/>
                    <a:ext cx="0" cy="270130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347229">
                        <a:moveTo>
                          <a:pt x="0" y="347229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A020F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78" name="pl257">
                    <a:extLst>
                      <a:ext uri="{FF2B5EF4-FFF2-40B4-BE49-F238E27FC236}">
                        <a16:creationId xmlns:a16="http://schemas.microsoft.com/office/drawing/2014/main" id="{6EC952FE-4313-A142-A6C4-50557A7CDA7A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456983" y="-999857"/>
                    <a:ext cx="0" cy="4977524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9375187">
                        <a:moveTo>
                          <a:pt x="0" y="9375187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CC9900"/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 dirty="0"/>
                  </a:p>
                </p:txBody>
              </p:sp>
              <p:cxnSp>
                <p:nvCxnSpPr>
                  <p:cNvPr id="79" name="Straight Connector 78">
                    <a:extLst>
                      <a:ext uri="{FF2B5EF4-FFF2-40B4-BE49-F238E27FC236}">
                        <a16:creationId xmlns:a16="http://schemas.microsoft.com/office/drawing/2014/main" id="{426EA881-CAB8-1CE2-5B70-3E7B5301747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968221" y="1509023"/>
                    <a:ext cx="1" cy="149767"/>
                  </a:xfrm>
                  <a:prstGeom prst="line">
                    <a:avLst/>
                  </a:prstGeom>
                  <a:ln w="9525" cap="flat" cmpd="sng" algn="ctr">
                    <a:solidFill>
                      <a:srgbClr val="CC9900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0" name="pl253">
                    <a:extLst>
                      <a:ext uri="{FF2B5EF4-FFF2-40B4-BE49-F238E27FC236}">
                        <a16:creationId xmlns:a16="http://schemas.microsoft.com/office/drawing/2014/main" id="{1D58DD07-A7E1-0E99-912C-F0D7F1AC5E78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4302803" y="3513"/>
                    <a:ext cx="0" cy="3285888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6076510">
                        <a:moveTo>
                          <a:pt x="0" y="6076510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00FFFF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81" name="pl255">
                    <a:extLst>
                      <a:ext uri="{FF2B5EF4-FFF2-40B4-BE49-F238E27FC236}">
                        <a16:creationId xmlns:a16="http://schemas.microsoft.com/office/drawing/2014/main" id="{D7D8A11F-6181-D32D-4186-4E91AD26A3E4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1836188" y="822787"/>
                    <a:ext cx="0" cy="1647341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2951448">
                        <a:moveTo>
                          <a:pt x="0" y="2951448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FF000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</p:grp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D80F2C57-DF15-5847-D196-D1ECBD636ABA}"/>
                    </a:ext>
                  </a:extLst>
                </p:cNvPr>
                <p:cNvSpPr txBox="1"/>
                <p:nvPr/>
              </p:nvSpPr>
              <p:spPr>
                <a:xfrm>
                  <a:off x="738188" y="54769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XC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306A9467-A07D-2F72-EE1A-3864E08B9EC2}"/>
                    </a:ext>
                  </a:extLst>
                </p:cNvPr>
                <p:cNvSpPr txBox="1"/>
                <p:nvPr/>
              </p:nvSpPr>
              <p:spPr>
                <a:xfrm>
                  <a:off x="3391596" y="-111102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EC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E128A322-AAA0-5689-E81C-2CC76AE24D62}"/>
                    </a:ext>
                  </a:extLst>
                </p:cNvPr>
                <p:cNvSpPr txBox="1"/>
                <p:nvPr/>
              </p:nvSpPr>
              <p:spPr>
                <a:xfrm>
                  <a:off x="1745433" y="56732"/>
                  <a:ext cx="18503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AFR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677D5FBD-2C49-8E35-C20B-318C2A349D57}"/>
                    </a:ext>
                  </a:extLst>
                </p:cNvPr>
                <p:cNvSpPr txBox="1"/>
                <p:nvPr/>
              </p:nvSpPr>
              <p:spPr>
                <a:xfrm>
                  <a:off x="4183473" y="56732"/>
                  <a:ext cx="24218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WIOI</a:t>
                  </a:r>
                </a:p>
              </p:txBody>
            </p:sp>
          </p:grp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C0BBD4F-2B70-62FF-BF68-2B2740862D15}"/>
                </a:ext>
              </a:extLst>
            </p:cNvPr>
            <p:cNvSpPr txBox="1"/>
            <p:nvPr/>
          </p:nvSpPr>
          <p:spPr>
            <a:xfrm>
              <a:off x="0" y="0"/>
              <a:ext cx="6227763" cy="8309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lvl="0" algn="just"/>
              <a:r>
                <a:rPr lang="en-GB" sz="1200" b="1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igure S1: </a:t>
              </a:r>
              <a:r>
                <a:rPr lang="en-GB" sz="1200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ox plots showing variation in each of the six measured leaf traits for all studied </a:t>
              </a:r>
              <a:r>
                <a:rPr lang="en-GB" sz="1200" i="1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Coffea</a:t>
              </a:r>
              <a:r>
                <a:rPr lang="en-GB" sz="1200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species (</a:t>
              </a:r>
              <a:r>
                <a:rPr lang="en-GB" sz="1200" b="1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</a:t>
              </a:r>
              <a:r>
                <a:rPr lang="en-GB" sz="1200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, </a:t>
              </a:r>
              <a:r>
                <a:rPr lang="en-GB" sz="1200" b="1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B</a:t>
              </a:r>
              <a:r>
                <a:rPr lang="en-GB" sz="1200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, </a:t>
              </a:r>
              <a:r>
                <a:rPr lang="en-GB" sz="1200" b="1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C</a:t>
              </a:r>
              <a:r>
                <a:rPr lang="en-GB" sz="1200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: n = 58; </a:t>
              </a:r>
              <a:r>
                <a:rPr lang="en-GB" sz="1200" b="1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D</a:t>
              </a:r>
              <a:r>
                <a:rPr lang="en-GB" sz="1200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, </a:t>
              </a:r>
              <a:r>
                <a:rPr lang="en-GB" sz="1200" b="1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E</a:t>
              </a:r>
              <a:r>
                <a:rPr lang="en-GB" sz="1200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, </a:t>
              </a:r>
              <a:r>
                <a:rPr lang="en-GB" sz="1200" b="1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</a:t>
              </a:r>
              <a:r>
                <a:rPr lang="en-GB" sz="1200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: n = 55). R</a:t>
              </a:r>
              <a:r>
                <a:rPr lang="en-GB" sz="1200" u="none" strike="noStrike" baseline="300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GB" sz="1200" u="none" strike="noStrike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and P-values are given in each figure. Coloured bars indicate (sub)clades. AFR = African; EC = Eu-coffee; WIOI = West Indian Ocean Islands; XC = Xeno-coffee. Clade nomenclature is based on Hamon et al. (2017).</a:t>
              </a:r>
              <a:endParaRPr lang="en-BE" sz="1100" u="none" strike="noStrike" dirty="0">
                <a:effectLst/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568996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0732867-395A-264D-7073-32DAEB9D198A}"/>
              </a:ext>
            </a:extLst>
          </p:cNvPr>
          <p:cNvGrpSpPr/>
          <p:nvPr/>
        </p:nvGrpSpPr>
        <p:grpSpPr>
          <a:xfrm>
            <a:off x="233881" y="835301"/>
            <a:ext cx="5760000" cy="5702853"/>
            <a:chOff x="233881" y="835301"/>
            <a:chExt cx="5760000" cy="5702853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B8EBB296-7739-80C9-C4A0-C9B30B32ABBE}"/>
                </a:ext>
              </a:extLst>
            </p:cNvPr>
            <p:cNvGrpSpPr/>
            <p:nvPr/>
          </p:nvGrpSpPr>
          <p:grpSpPr>
            <a:xfrm>
              <a:off x="233881" y="835301"/>
              <a:ext cx="5760000" cy="2846029"/>
              <a:chOff x="233881" y="835301"/>
              <a:chExt cx="5760000" cy="2846029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E42A8C24-A947-9EE5-9494-DF6EE7356EB0}"/>
                  </a:ext>
                </a:extLst>
              </p:cNvPr>
              <p:cNvGrpSpPr/>
              <p:nvPr/>
            </p:nvGrpSpPr>
            <p:grpSpPr>
              <a:xfrm>
                <a:off x="233881" y="955766"/>
                <a:ext cx="5760000" cy="2725564"/>
                <a:chOff x="233881" y="5408940"/>
                <a:chExt cx="5760000" cy="2725564"/>
              </a:xfrm>
            </p:grpSpPr>
            <p:pic>
              <p:nvPicPr>
                <p:cNvPr id="9" name="Picture 8" descr="A graph with many letter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CDA26D41-123D-A89E-40D5-225100C392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alphaModFix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824"/>
                <a:stretch/>
              </p:blipFill>
              <p:spPr>
                <a:xfrm>
                  <a:off x="233881" y="5408940"/>
                  <a:ext cx="5760000" cy="2725564"/>
                </a:xfrm>
                <a:prstGeom prst="rect">
                  <a:avLst/>
                </a:prstGeom>
              </p:spPr>
            </p:pic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9E9D8DCC-D327-53A1-7D2E-5C968117600C}"/>
                    </a:ext>
                  </a:extLst>
                </p:cNvPr>
                <p:cNvSpPr txBox="1"/>
                <p:nvPr/>
              </p:nvSpPr>
              <p:spPr>
                <a:xfrm>
                  <a:off x="5402580" y="5679440"/>
                  <a:ext cx="51816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i="1" dirty="0"/>
                    <a:t>R</a:t>
                  </a:r>
                  <a:r>
                    <a:rPr lang="en-BE" sz="800" i="1" baseline="30000" dirty="0"/>
                    <a:t>2</a:t>
                  </a:r>
                  <a:r>
                    <a:rPr lang="en-BE" sz="800" i="1" baseline="-25000" dirty="0"/>
                    <a:t>adj</a:t>
                  </a:r>
                  <a:r>
                    <a:rPr lang="en-BE" sz="800" i="1" dirty="0"/>
                    <a:t> = 0.74</a:t>
                  </a:r>
                </a:p>
                <a:p>
                  <a:r>
                    <a:rPr lang="en-BE" sz="800" i="1" dirty="0"/>
                    <a:t>p &lt; 2.2e-16</a:t>
                  </a:r>
                </a:p>
              </p:txBody>
            </p:sp>
          </p:grpSp>
          <p:grpSp>
            <p:nvGrpSpPr>
              <p:cNvPr id="83" name="Group 82">
                <a:extLst>
                  <a:ext uri="{FF2B5EF4-FFF2-40B4-BE49-F238E27FC236}">
                    <a16:creationId xmlns:a16="http://schemas.microsoft.com/office/drawing/2014/main" id="{09A88BAF-3C1C-CF9F-DEC2-5EF69C17101B}"/>
                  </a:ext>
                </a:extLst>
              </p:cNvPr>
              <p:cNvGrpSpPr/>
              <p:nvPr/>
            </p:nvGrpSpPr>
            <p:grpSpPr>
              <a:xfrm>
                <a:off x="581828" y="835301"/>
                <a:ext cx="5365679" cy="315638"/>
                <a:chOff x="651722" y="-111102"/>
                <a:chExt cx="5295789" cy="315638"/>
              </a:xfrm>
            </p:grpSpPr>
            <p:grpSp>
              <p:nvGrpSpPr>
                <p:cNvPr id="84" name="Group 83">
                  <a:extLst>
                    <a:ext uri="{FF2B5EF4-FFF2-40B4-BE49-F238E27FC236}">
                      <a16:creationId xmlns:a16="http://schemas.microsoft.com/office/drawing/2014/main" id="{C71136F3-F6E3-FBAC-77F8-49E37156CB88}"/>
                    </a:ext>
                  </a:extLst>
                </p:cNvPr>
                <p:cNvGrpSpPr/>
                <p:nvPr/>
              </p:nvGrpSpPr>
              <p:grpSpPr>
                <a:xfrm>
                  <a:off x="651722" y="34651"/>
                  <a:ext cx="5295789" cy="169885"/>
                  <a:chOff x="649958" y="1488905"/>
                  <a:chExt cx="5295789" cy="169885"/>
                </a:xfrm>
              </p:grpSpPr>
              <p:sp>
                <p:nvSpPr>
                  <p:cNvPr id="89" name="pl259">
                    <a:extLst>
                      <a:ext uri="{FF2B5EF4-FFF2-40B4-BE49-F238E27FC236}">
                        <a16:creationId xmlns:a16="http://schemas.microsoft.com/office/drawing/2014/main" id="{3DB4AB7F-77D7-FE71-8B8F-956E704F9879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785023" y="1511391"/>
                    <a:ext cx="0" cy="270130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347229">
                        <a:moveTo>
                          <a:pt x="0" y="347229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A020F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90" name="pl257">
                    <a:extLst>
                      <a:ext uri="{FF2B5EF4-FFF2-40B4-BE49-F238E27FC236}">
                        <a16:creationId xmlns:a16="http://schemas.microsoft.com/office/drawing/2014/main" id="{60085EC9-9392-5685-5826-4523AF60B863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456983" y="-999857"/>
                    <a:ext cx="0" cy="4977524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9375187">
                        <a:moveTo>
                          <a:pt x="0" y="9375187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CC9900"/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 dirty="0"/>
                  </a:p>
                </p:txBody>
              </p:sp>
              <p:cxnSp>
                <p:nvCxnSpPr>
                  <p:cNvPr id="91" name="Straight Connector 90">
                    <a:extLst>
                      <a:ext uri="{FF2B5EF4-FFF2-40B4-BE49-F238E27FC236}">
                        <a16:creationId xmlns:a16="http://schemas.microsoft.com/office/drawing/2014/main" id="{4A9A6009-3FB1-AD45-1EE7-066296436B4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968221" y="1509023"/>
                    <a:ext cx="1" cy="149767"/>
                  </a:xfrm>
                  <a:prstGeom prst="line">
                    <a:avLst/>
                  </a:prstGeom>
                  <a:ln w="9525" cap="flat" cmpd="sng" algn="ctr">
                    <a:solidFill>
                      <a:srgbClr val="CC9900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2" name="pl253">
                    <a:extLst>
                      <a:ext uri="{FF2B5EF4-FFF2-40B4-BE49-F238E27FC236}">
                        <a16:creationId xmlns:a16="http://schemas.microsoft.com/office/drawing/2014/main" id="{72314F64-95C8-2F4F-E272-E5D58937AA4B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4302803" y="3513"/>
                    <a:ext cx="0" cy="3285888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6076510">
                        <a:moveTo>
                          <a:pt x="0" y="6076510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00FFFF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93" name="pl255">
                    <a:extLst>
                      <a:ext uri="{FF2B5EF4-FFF2-40B4-BE49-F238E27FC236}">
                        <a16:creationId xmlns:a16="http://schemas.microsoft.com/office/drawing/2014/main" id="{855A8B40-4110-1115-A079-5FC3113248BA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1836188" y="822787"/>
                    <a:ext cx="0" cy="1647341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2951448">
                        <a:moveTo>
                          <a:pt x="0" y="2951448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FF000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</p:grp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FF443B57-25A1-697B-6BB2-F23F8138750D}"/>
                    </a:ext>
                  </a:extLst>
                </p:cNvPr>
                <p:cNvSpPr txBox="1"/>
                <p:nvPr/>
              </p:nvSpPr>
              <p:spPr>
                <a:xfrm>
                  <a:off x="738188" y="54769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XC</a:t>
                  </a: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DFAA076A-BB7B-48D5-0B36-1D3BD0447685}"/>
                    </a:ext>
                  </a:extLst>
                </p:cNvPr>
                <p:cNvSpPr txBox="1"/>
                <p:nvPr/>
              </p:nvSpPr>
              <p:spPr>
                <a:xfrm>
                  <a:off x="3391596" y="-111102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EC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7FCC0843-332C-AB1A-B395-F14D113FC6A5}"/>
                    </a:ext>
                  </a:extLst>
                </p:cNvPr>
                <p:cNvSpPr txBox="1"/>
                <p:nvPr/>
              </p:nvSpPr>
              <p:spPr>
                <a:xfrm>
                  <a:off x="1745433" y="56732"/>
                  <a:ext cx="18503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AFR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DD5B8B27-C1D1-35B2-C913-8D7BA8BFFE40}"/>
                    </a:ext>
                  </a:extLst>
                </p:cNvPr>
                <p:cNvSpPr txBox="1"/>
                <p:nvPr/>
              </p:nvSpPr>
              <p:spPr>
                <a:xfrm>
                  <a:off x="4183473" y="56732"/>
                  <a:ext cx="24218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WIOI</a:t>
                  </a:r>
                </a:p>
              </p:txBody>
            </p:sp>
          </p:grp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7980C5C9-A72F-DE1B-1A9B-D8E17AB3B8A9}"/>
                </a:ext>
              </a:extLst>
            </p:cNvPr>
            <p:cNvGrpSpPr/>
            <p:nvPr/>
          </p:nvGrpSpPr>
          <p:grpSpPr>
            <a:xfrm>
              <a:off x="305881" y="3726736"/>
              <a:ext cx="5688000" cy="2811418"/>
              <a:chOff x="305881" y="3935601"/>
              <a:chExt cx="5688000" cy="2811418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8C68F958-635D-4CD4-A0FC-D9613CD14158}"/>
                  </a:ext>
                </a:extLst>
              </p:cNvPr>
              <p:cNvGrpSpPr/>
              <p:nvPr/>
            </p:nvGrpSpPr>
            <p:grpSpPr>
              <a:xfrm>
                <a:off x="305881" y="4038601"/>
                <a:ext cx="5688000" cy="2708418"/>
                <a:chOff x="233881" y="1"/>
                <a:chExt cx="5688000" cy="2708418"/>
              </a:xfrm>
            </p:grpSpPr>
            <p:pic>
              <p:nvPicPr>
                <p:cNvPr id="7" name="Picture 6" descr="A graph with many black and white text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F90E480B-A126-5DED-58CC-6476F989A48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271"/>
                <a:stretch/>
              </p:blipFill>
              <p:spPr>
                <a:xfrm>
                  <a:off x="233881" y="1"/>
                  <a:ext cx="5688000" cy="2708418"/>
                </a:xfrm>
                <a:prstGeom prst="rect">
                  <a:avLst/>
                </a:prstGeom>
              </p:spPr>
            </p:pic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AEAF22E7-11F8-FF93-3FB5-65E44E54C8E7}"/>
                    </a:ext>
                  </a:extLst>
                </p:cNvPr>
                <p:cNvSpPr txBox="1"/>
                <p:nvPr/>
              </p:nvSpPr>
              <p:spPr>
                <a:xfrm>
                  <a:off x="584200" y="1426591"/>
                  <a:ext cx="51816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i="1" dirty="0"/>
                    <a:t>R</a:t>
                  </a:r>
                  <a:r>
                    <a:rPr lang="en-BE" sz="800" i="1" baseline="30000" dirty="0"/>
                    <a:t>2</a:t>
                  </a:r>
                  <a:r>
                    <a:rPr lang="en-BE" sz="800" i="1" baseline="-25000" dirty="0"/>
                    <a:t>adj</a:t>
                  </a:r>
                  <a:r>
                    <a:rPr lang="en-BE" sz="800" i="1" dirty="0"/>
                    <a:t> = 0.61</a:t>
                  </a:r>
                </a:p>
                <a:p>
                  <a:r>
                    <a:rPr lang="en-BE" sz="800" i="1" dirty="0"/>
                    <a:t>p &lt; 2.2e-16</a:t>
                  </a:r>
                </a:p>
              </p:txBody>
            </p:sp>
          </p:grpSp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6076744D-2448-F7EC-3B14-CA0759EE4A54}"/>
                  </a:ext>
                </a:extLst>
              </p:cNvPr>
              <p:cNvGrpSpPr/>
              <p:nvPr/>
            </p:nvGrpSpPr>
            <p:grpSpPr>
              <a:xfrm>
                <a:off x="631825" y="3935601"/>
                <a:ext cx="5315679" cy="315638"/>
                <a:chOff x="651722" y="-111102"/>
                <a:chExt cx="5295789" cy="315638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FACB6AD3-54A2-DAE6-206E-09591466E757}"/>
                    </a:ext>
                  </a:extLst>
                </p:cNvPr>
                <p:cNvGrpSpPr/>
                <p:nvPr/>
              </p:nvGrpSpPr>
              <p:grpSpPr>
                <a:xfrm>
                  <a:off x="651722" y="34651"/>
                  <a:ext cx="5295789" cy="169885"/>
                  <a:chOff x="649958" y="1488905"/>
                  <a:chExt cx="5295789" cy="169885"/>
                </a:xfrm>
              </p:grpSpPr>
              <p:sp>
                <p:nvSpPr>
                  <p:cNvPr id="16" name="pl259">
                    <a:extLst>
                      <a:ext uri="{FF2B5EF4-FFF2-40B4-BE49-F238E27FC236}">
                        <a16:creationId xmlns:a16="http://schemas.microsoft.com/office/drawing/2014/main" id="{388DEF91-E319-373B-77A5-6D1CC70C5E13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785023" y="1511391"/>
                    <a:ext cx="0" cy="270130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347229">
                        <a:moveTo>
                          <a:pt x="0" y="347229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A020F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17" name="pl257">
                    <a:extLst>
                      <a:ext uri="{FF2B5EF4-FFF2-40B4-BE49-F238E27FC236}">
                        <a16:creationId xmlns:a16="http://schemas.microsoft.com/office/drawing/2014/main" id="{805D6951-146D-9BD4-1296-ED552FD2E6DD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456983" y="-999857"/>
                    <a:ext cx="0" cy="4977524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9375187">
                        <a:moveTo>
                          <a:pt x="0" y="9375187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CC9900"/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 dirty="0"/>
                  </a:p>
                </p:txBody>
              </p:sp>
              <p:cxnSp>
                <p:nvCxnSpPr>
                  <p:cNvPr id="18" name="Straight Connector 17">
                    <a:extLst>
                      <a:ext uri="{FF2B5EF4-FFF2-40B4-BE49-F238E27FC236}">
                        <a16:creationId xmlns:a16="http://schemas.microsoft.com/office/drawing/2014/main" id="{B7313282-85A3-3ECF-8274-72054C99AC5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968221" y="1509023"/>
                    <a:ext cx="1" cy="149767"/>
                  </a:xfrm>
                  <a:prstGeom prst="line">
                    <a:avLst/>
                  </a:prstGeom>
                  <a:ln w="9525" cap="flat" cmpd="sng" algn="ctr">
                    <a:solidFill>
                      <a:srgbClr val="CC9900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" name="pl253">
                    <a:extLst>
                      <a:ext uri="{FF2B5EF4-FFF2-40B4-BE49-F238E27FC236}">
                        <a16:creationId xmlns:a16="http://schemas.microsoft.com/office/drawing/2014/main" id="{9542B06C-C6C3-DD8E-7A71-4E074459E103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4302803" y="3513"/>
                    <a:ext cx="0" cy="3285888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6076510">
                        <a:moveTo>
                          <a:pt x="0" y="6076510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00FFFF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20" name="pl255">
                    <a:extLst>
                      <a:ext uri="{FF2B5EF4-FFF2-40B4-BE49-F238E27FC236}">
                        <a16:creationId xmlns:a16="http://schemas.microsoft.com/office/drawing/2014/main" id="{45A25862-FB3D-5E44-DF61-6B4AEF9C2140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1836188" y="822787"/>
                    <a:ext cx="0" cy="1647341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2951448">
                        <a:moveTo>
                          <a:pt x="0" y="2951448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FF000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</p:grp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CCA1CBE5-6DB4-6ED7-E449-483E962781E1}"/>
                    </a:ext>
                  </a:extLst>
                </p:cNvPr>
                <p:cNvSpPr txBox="1"/>
                <p:nvPr/>
              </p:nvSpPr>
              <p:spPr>
                <a:xfrm>
                  <a:off x="738188" y="54769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XC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B7D8E555-8DB6-10D8-CC61-836A675726EA}"/>
                    </a:ext>
                  </a:extLst>
                </p:cNvPr>
                <p:cNvSpPr txBox="1"/>
                <p:nvPr/>
              </p:nvSpPr>
              <p:spPr>
                <a:xfrm>
                  <a:off x="3391596" y="-111102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EC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25B55700-E48E-EE4D-B183-4E5EE12FD867}"/>
                    </a:ext>
                  </a:extLst>
                </p:cNvPr>
                <p:cNvSpPr txBox="1"/>
                <p:nvPr/>
              </p:nvSpPr>
              <p:spPr>
                <a:xfrm>
                  <a:off x="1745433" y="56732"/>
                  <a:ext cx="18503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AFR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2221B124-C724-68D5-3D65-43899156CD44}"/>
                    </a:ext>
                  </a:extLst>
                </p:cNvPr>
                <p:cNvSpPr txBox="1"/>
                <p:nvPr/>
              </p:nvSpPr>
              <p:spPr>
                <a:xfrm>
                  <a:off x="4183473" y="56732"/>
                  <a:ext cx="24218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WIOI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492574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604CF21-4E98-7439-FE3B-8920216899AF}"/>
              </a:ext>
            </a:extLst>
          </p:cNvPr>
          <p:cNvGrpSpPr/>
          <p:nvPr/>
        </p:nvGrpSpPr>
        <p:grpSpPr>
          <a:xfrm>
            <a:off x="269881" y="1242812"/>
            <a:ext cx="5688000" cy="5763376"/>
            <a:chOff x="269881" y="1242812"/>
            <a:chExt cx="5688000" cy="5763376"/>
          </a:xfrm>
        </p:grpSpPr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646023AA-C002-3D1F-D19D-74A7D9A4A5E4}"/>
                </a:ext>
              </a:extLst>
            </p:cNvPr>
            <p:cNvGrpSpPr/>
            <p:nvPr/>
          </p:nvGrpSpPr>
          <p:grpSpPr>
            <a:xfrm>
              <a:off x="269881" y="1242812"/>
              <a:ext cx="5688000" cy="2833940"/>
              <a:chOff x="269881" y="1242812"/>
              <a:chExt cx="5688000" cy="2833940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C17280ED-A1D4-485A-2170-974934B41B7F}"/>
                  </a:ext>
                </a:extLst>
              </p:cNvPr>
              <p:cNvGrpSpPr/>
              <p:nvPr/>
            </p:nvGrpSpPr>
            <p:grpSpPr>
              <a:xfrm>
                <a:off x="269881" y="1368334"/>
                <a:ext cx="5688000" cy="2708418"/>
                <a:chOff x="233881" y="2708419"/>
                <a:chExt cx="5688000" cy="2708418"/>
              </a:xfrm>
            </p:grpSpPr>
            <p:pic>
              <p:nvPicPr>
                <p:cNvPr id="9" name="Picture 8" descr="A graph with many letter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1C083552-1882-BF19-74F4-C123E2080A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alphaModFix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359"/>
                <a:stretch/>
              </p:blipFill>
              <p:spPr>
                <a:xfrm>
                  <a:off x="233881" y="2708419"/>
                  <a:ext cx="5688000" cy="2708418"/>
                </a:xfrm>
                <a:prstGeom prst="rect">
                  <a:avLst/>
                </a:prstGeom>
              </p:spPr>
            </p:pic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2B14BC77-5320-0BF1-C52B-F1BDB7212F57}"/>
                    </a:ext>
                  </a:extLst>
                </p:cNvPr>
                <p:cNvSpPr txBox="1"/>
                <p:nvPr/>
              </p:nvSpPr>
              <p:spPr>
                <a:xfrm>
                  <a:off x="5332730" y="2966579"/>
                  <a:ext cx="51816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i="1" dirty="0"/>
                    <a:t>R</a:t>
                  </a:r>
                  <a:r>
                    <a:rPr lang="en-BE" sz="800" i="1" baseline="30000" dirty="0"/>
                    <a:t>2</a:t>
                  </a:r>
                  <a:r>
                    <a:rPr lang="en-BE" sz="800" i="1" baseline="-25000" dirty="0"/>
                    <a:t>adj</a:t>
                  </a:r>
                  <a:r>
                    <a:rPr lang="en-BE" sz="800" i="1" dirty="0"/>
                    <a:t> = 0.53</a:t>
                  </a:r>
                </a:p>
                <a:p>
                  <a:r>
                    <a:rPr lang="en-BE" sz="800" i="1" dirty="0"/>
                    <a:t>p &lt; 2.2e-16</a:t>
                  </a:r>
                </a:p>
              </p:txBody>
            </p:sp>
          </p:grpSp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CF5AF131-17E4-7CCC-A0F4-17673AF71D9B}"/>
                  </a:ext>
                </a:extLst>
              </p:cNvPr>
              <p:cNvGrpSpPr/>
              <p:nvPr/>
            </p:nvGrpSpPr>
            <p:grpSpPr>
              <a:xfrm>
                <a:off x="593725" y="1242812"/>
                <a:ext cx="5314879" cy="315638"/>
                <a:chOff x="651722" y="-111102"/>
                <a:chExt cx="5295789" cy="315638"/>
              </a:xfrm>
            </p:grpSpPr>
            <p:grpSp>
              <p:nvGrpSpPr>
                <p:cNvPr id="4" name="Group 3">
                  <a:extLst>
                    <a:ext uri="{FF2B5EF4-FFF2-40B4-BE49-F238E27FC236}">
                      <a16:creationId xmlns:a16="http://schemas.microsoft.com/office/drawing/2014/main" id="{02141ECD-5E65-9089-AD75-F8041F5C0DAC}"/>
                    </a:ext>
                  </a:extLst>
                </p:cNvPr>
                <p:cNvGrpSpPr/>
                <p:nvPr/>
              </p:nvGrpSpPr>
              <p:grpSpPr>
                <a:xfrm>
                  <a:off x="651722" y="34651"/>
                  <a:ext cx="5295789" cy="169885"/>
                  <a:chOff x="649958" y="1488905"/>
                  <a:chExt cx="5295789" cy="169885"/>
                </a:xfrm>
              </p:grpSpPr>
              <p:sp>
                <p:nvSpPr>
                  <p:cNvPr id="18" name="pl259">
                    <a:extLst>
                      <a:ext uri="{FF2B5EF4-FFF2-40B4-BE49-F238E27FC236}">
                        <a16:creationId xmlns:a16="http://schemas.microsoft.com/office/drawing/2014/main" id="{B97773CC-0A8A-6D4C-DB98-F71005D8D576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785023" y="1511391"/>
                    <a:ext cx="0" cy="270130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347229">
                        <a:moveTo>
                          <a:pt x="0" y="347229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A020F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19" name="pl257">
                    <a:extLst>
                      <a:ext uri="{FF2B5EF4-FFF2-40B4-BE49-F238E27FC236}">
                        <a16:creationId xmlns:a16="http://schemas.microsoft.com/office/drawing/2014/main" id="{AB1B1EAD-B1B4-B652-3AD6-5D8E13E65C92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456983" y="-999857"/>
                    <a:ext cx="0" cy="4977524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9375187">
                        <a:moveTo>
                          <a:pt x="0" y="9375187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CC9900"/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 dirty="0"/>
                  </a:p>
                </p:txBody>
              </p:sp>
              <p:cxnSp>
                <p:nvCxnSpPr>
                  <p:cNvPr id="20" name="Straight Connector 19">
                    <a:extLst>
                      <a:ext uri="{FF2B5EF4-FFF2-40B4-BE49-F238E27FC236}">
                        <a16:creationId xmlns:a16="http://schemas.microsoft.com/office/drawing/2014/main" id="{AE5D0B87-FFF9-21B5-31D1-7B31F5AA73A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968221" y="1509023"/>
                    <a:ext cx="1" cy="149767"/>
                  </a:xfrm>
                  <a:prstGeom prst="line">
                    <a:avLst/>
                  </a:prstGeom>
                  <a:ln w="9525" cap="flat" cmpd="sng" algn="ctr">
                    <a:solidFill>
                      <a:srgbClr val="CC9900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" name="pl253">
                    <a:extLst>
                      <a:ext uri="{FF2B5EF4-FFF2-40B4-BE49-F238E27FC236}">
                        <a16:creationId xmlns:a16="http://schemas.microsoft.com/office/drawing/2014/main" id="{17057702-376B-F547-8C43-8B6ED06CEFA1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4302803" y="3513"/>
                    <a:ext cx="0" cy="3285888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6076510">
                        <a:moveTo>
                          <a:pt x="0" y="6076510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00FFFF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22" name="pl255">
                    <a:extLst>
                      <a:ext uri="{FF2B5EF4-FFF2-40B4-BE49-F238E27FC236}">
                        <a16:creationId xmlns:a16="http://schemas.microsoft.com/office/drawing/2014/main" id="{38EF9DA5-6612-EDE9-1395-809DE80B9775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1836188" y="822787"/>
                    <a:ext cx="0" cy="1647341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2951448">
                        <a:moveTo>
                          <a:pt x="0" y="2951448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FF000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</p:grp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5F0CA641-E98A-36EE-1FA3-AC3FAA54DACE}"/>
                    </a:ext>
                  </a:extLst>
                </p:cNvPr>
                <p:cNvSpPr txBox="1"/>
                <p:nvPr/>
              </p:nvSpPr>
              <p:spPr>
                <a:xfrm>
                  <a:off x="738188" y="54769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XC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5B781C6D-CDAF-472F-3E70-509569D83E45}"/>
                    </a:ext>
                  </a:extLst>
                </p:cNvPr>
                <p:cNvSpPr txBox="1"/>
                <p:nvPr/>
              </p:nvSpPr>
              <p:spPr>
                <a:xfrm>
                  <a:off x="3391596" y="-111102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EC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0C59E46B-80F4-BEA9-901C-98E81510C12D}"/>
                    </a:ext>
                  </a:extLst>
                </p:cNvPr>
                <p:cNvSpPr txBox="1"/>
                <p:nvPr/>
              </p:nvSpPr>
              <p:spPr>
                <a:xfrm>
                  <a:off x="1745433" y="56732"/>
                  <a:ext cx="18503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AFR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8A18DF84-BAB1-70AC-E452-CF9A10B89125}"/>
                    </a:ext>
                  </a:extLst>
                </p:cNvPr>
                <p:cNvSpPr txBox="1"/>
                <p:nvPr/>
              </p:nvSpPr>
              <p:spPr>
                <a:xfrm>
                  <a:off x="4183473" y="56732"/>
                  <a:ext cx="24218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WIOI</a:t>
                  </a:r>
                </a:p>
              </p:txBody>
            </p:sp>
          </p:grp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0E112B6C-24E1-1076-A8C5-152A96B56A4B}"/>
                </a:ext>
              </a:extLst>
            </p:cNvPr>
            <p:cNvGrpSpPr/>
            <p:nvPr/>
          </p:nvGrpSpPr>
          <p:grpSpPr>
            <a:xfrm>
              <a:off x="269881" y="4127500"/>
              <a:ext cx="5688000" cy="2878688"/>
              <a:chOff x="269881" y="4421908"/>
              <a:chExt cx="5688000" cy="2878688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69DA5AFD-DF2F-2E55-73A4-5FA5844EF3EA}"/>
                  </a:ext>
                </a:extLst>
              </p:cNvPr>
              <p:cNvGrpSpPr/>
              <p:nvPr/>
            </p:nvGrpSpPr>
            <p:grpSpPr>
              <a:xfrm>
                <a:off x="269881" y="4541178"/>
                <a:ext cx="5688000" cy="2759418"/>
                <a:chOff x="233881" y="5417478"/>
                <a:chExt cx="5688000" cy="2759418"/>
              </a:xfrm>
            </p:grpSpPr>
            <p:pic>
              <p:nvPicPr>
                <p:cNvPr id="11" name="Picture 10" descr="A graph with numbers and letter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AC7AED7A-B796-9B46-8865-60A923CB111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alphaModFix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401" b="1"/>
                <a:stretch/>
              </p:blipFill>
              <p:spPr>
                <a:xfrm>
                  <a:off x="233881" y="5417478"/>
                  <a:ext cx="5688000" cy="2759418"/>
                </a:xfrm>
                <a:prstGeom prst="rect">
                  <a:avLst/>
                </a:prstGeom>
              </p:spPr>
            </p:pic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A256FD77-3752-71F6-29C5-4DD2BA744BF0}"/>
                    </a:ext>
                  </a:extLst>
                </p:cNvPr>
                <p:cNvSpPr txBox="1"/>
                <p:nvPr/>
              </p:nvSpPr>
              <p:spPr>
                <a:xfrm>
                  <a:off x="530352" y="5672391"/>
                  <a:ext cx="51816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i="1" dirty="0"/>
                    <a:t>R</a:t>
                  </a:r>
                  <a:r>
                    <a:rPr lang="en-BE" sz="800" i="1" baseline="30000" dirty="0"/>
                    <a:t>2</a:t>
                  </a:r>
                  <a:r>
                    <a:rPr lang="en-BE" sz="800" i="1" baseline="-25000" dirty="0"/>
                    <a:t>adj</a:t>
                  </a:r>
                  <a:r>
                    <a:rPr lang="en-BE" sz="800" i="1" dirty="0"/>
                    <a:t> = 0.36</a:t>
                  </a:r>
                </a:p>
                <a:p>
                  <a:r>
                    <a:rPr lang="en-BE" sz="800" i="1" dirty="0"/>
                    <a:t>p &lt; 2.2e-16</a:t>
                  </a:r>
                </a:p>
              </p:txBody>
            </p:sp>
          </p:grp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1C628CC9-47D3-5F56-DDC9-4CFCA8EEBDC9}"/>
                  </a:ext>
                </a:extLst>
              </p:cNvPr>
              <p:cNvGrpSpPr/>
              <p:nvPr/>
            </p:nvGrpSpPr>
            <p:grpSpPr>
              <a:xfrm>
                <a:off x="542925" y="4421908"/>
                <a:ext cx="5366879" cy="315638"/>
                <a:chOff x="651722" y="-111102"/>
                <a:chExt cx="5295789" cy="315638"/>
              </a:xfrm>
            </p:grpSpPr>
            <p:grpSp>
              <p:nvGrpSpPr>
                <p:cNvPr id="24" name="Group 23">
                  <a:extLst>
                    <a:ext uri="{FF2B5EF4-FFF2-40B4-BE49-F238E27FC236}">
                      <a16:creationId xmlns:a16="http://schemas.microsoft.com/office/drawing/2014/main" id="{21B12948-80DA-9960-C7BD-7727783E4223}"/>
                    </a:ext>
                  </a:extLst>
                </p:cNvPr>
                <p:cNvGrpSpPr/>
                <p:nvPr/>
              </p:nvGrpSpPr>
              <p:grpSpPr>
                <a:xfrm>
                  <a:off x="651722" y="34651"/>
                  <a:ext cx="5295789" cy="169885"/>
                  <a:chOff x="649958" y="1488905"/>
                  <a:chExt cx="5295789" cy="169885"/>
                </a:xfrm>
              </p:grpSpPr>
              <p:sp>
                <p:nvSpPr>
                  <p:cNvPr id="29" name="pl259">
                    <a:extLst>
                      <a:ext uri="{FF2B5EF4-FFF2-40B4-BE49-F238E27FC236}">
                        <a16:creationId xmlns:a16="http://schemas.microsoft.com/office/drawing/2014/main" id="{FE242BEC-8797-64DB-5185-A0F671F794E6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785023" y="1511391"/>
                    <a:ext cx="0" cy="270130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347229">
                        <a:moveTo>
                          <a:pt x="0" y="347229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A020F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30" name="pl257">
                    <a:extLst>
                      <a:ext uri="{FF2B5EF4-FFF2-40B4-BE49-F238E27FC236}">
                        <a16:creationId xmlns:a16="http://schemas.microsoft.com/office/drawing/2014/main" id="{39A9B7F9-83DE-6668-4A24-DB0EFE3935FF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456983" y="-999857"/>
                    <a:ext cx="0" cy="4977524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9375187">
                        <a:moveTo>
                          <a:pt x="0" y="9375187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CC9900"/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 dirty="0"/>
                  </a:p>
                </p:txBody>
              </p:sp>
              <p:cxnSp>
                <p:nvCxnSpPr>
                  <p:cNvPr id="31" name="Straight Connector 30">
                    <a:extLst>
                      <a:ext uri="{FF2B5EF4-FFF2-40B4-BE49-F238E27FC236}">
                        <a16:creationId xmlns:a16="http://schemas.microsoft.com/office/drawing/2014/main" id="{825A7319-7F43-F7F6-CF7F-3C32CE49686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968221" y="1509023"/>
                    <a:ext cx="1" cy="149767"/>
                  </a:xfrm>
                  <a:prstGeom prst="line">
                    <a:avLst/>
                  </a:prstGeom>
                  <a:ln w="9525" cap="flat" cmpd="sng" algn="ctr">
                    <a:solidFill>
                      <a:srgbClr val="CC9900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" name="pl253">
                    <a:extLst>
                      <a:ext uri="{FF2B5EF4-FFF2-40B4-BE49-F238E27FC236}">
                        <a16:creationId xmlns:a16="http://schemas.microsoft.com/office/drawing/2014/main" id="{388F499C-9994-EF07-C83B-7B61E8F4FD64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4302803" y="3513"/>
                    <a:ext cx="0" cy="3285888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6076510">
                        <a:moveTo>
                          <a:pt x="0" y="6076510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00FFFF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  <p:sp>
                <p:nvSpPr>
                  <p:cNvPr id="33" name="pl255">
                    <a:extLst>
                      <a:ext uri="{FF2B5EF4-FFF2-40B4-BE49-F238E27FC236}">
                        <a16:creationId xmlns:a16="http://schemas.microsoft.com/office/drawing/2014/main" id="{ADBAB8F3-90FE-1DEB-273C-D5FDD0E36E02}"/>
                      </a:ext>
                    </a:extLst>
                  </p:cNvPr>
                  <p:cNvSpPr/>
                  <p:nvPr/>
                </p:nvSpPr>
                <p:spPr>
                  <a:xfrm rot="16200000" flipH="1">
                    <a:off x="1836188" y="822787"/>
                    <a:ext cx="0" cy="1647341"/>
                  </a:xfrm>
                  <a:custGeom>
                    <a:avLst/>
                    <a:gdLst/>
                    <a:ahLst/>
                    <a:cxnLst/>
                    <a:rect l="0" t="0" r="0" b="0"/>
                    <a:pathLst>
                      <a:path h="2951448">
                        <a:moveTo>
                          <a:pt x="0" y="2951448"/>
                        </a:moveTo>
                        <a:lnTo>
                          <a:pt x="0" y="0"/>
                        </a:lnTo>
                      </a:path>
                    </a:pathLst>
                  </a:custGeom>
                  <a:ln w="19050" cap="flat">
                    <a:solidFill>
                      <a:srgbClr val="FF0000">
                        <a:alpha val="100000"/>
                      </a:srgbClr>
                    </a:solidFill>
                    <a:prstDash val="solid"/>
                    <a:round/>
                  </a:ln>
                </p:spPr>
                <p:txBody>
                  <a:bodyPr/>
                  <a:lstStyle/>
                  <a:p>
                    <a:endParaRPr sz="529"/>
                  </a:p>
                </p:txBody>
              </p:sp>
            </p:grp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E7AD342E-18A8-DDDD-92EB-7639AB22B518}"/>
                    </a:ext>
                  </a:extLst>
                </p:cNvPr>
                <p:cNvSpPr txBox="1"/>
                <p:nvPr/>
              </p:nvSpPr>
              <p:spPr>
                <a:xfrm>
                  <a:off x="738188" y="54769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XC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89151E0F-2A5A-3B46-5801-91F919DD16ED}"/>
                    </a:ext>
                  </a:extLst>
                </p:cNvPr>
                <p:cNvSpPr txBox="1"/>
                <p:nvPr/>
              </p:nvSpPr>
              <p:spPr>
                <a:xfrm>
                  <a:off x="3391596" y="-111102"/>
                  <a:ext cx="134302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EC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2AF4595C-9E57-6AB2-C8B8-8D877D6C69FC}"/>
                    </a:ext>
                  </a:extLst>
                </p:cNvPr>
                <p:cNvSpPr txBox="1"/>
                <p:nvPr/>
              </p:nvSpPr>
              <p:spPr>
                <a:xfrm>
                  <a:off x="1745433" y="56732"/>
                  <a:ext cx="18503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AFR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3DE4057D-33AE-962F-C0D3-560E4E633624}"/>
                    </a:ext>
                  </a:extLst>
                </p:cNvPr>
                <p:cNvSpPr txBox="1"/>
                <p:nvPr/>
              </p:nvSpPr>
              <p:spPr>
                <a:xfrm>
                  <a:off x="4183473" y="56732"/>
                  <a:ext cx="242187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BE" sz="800" dirty="0"/>
                    <a:t>WIOI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958301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</TotalTime>
  <Words>149</Words>
  <Application>Microsoft Office PowerPoint</Application>
  <PresentationFormat>Custom</PresentationFormat>
  <Paragraphs>3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den Hendrickx</dc:creator>
  <cp:lastModifiedBy>Aiden Hendrickx</cp:lastModifiedBy>
  <cp:revision>6</cp:revision>
  <dcterms:created xsi:type="dcterms:W3CDTF">2023-12-20T09:14:21Z</dcterms:created>
  <dcterms:modified xsi:type="dcterms:W3CDTF">2024-02-13T10:02:31Z</dcterms:modified>
</cp:coreProperties>
</file>